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5" r:id="rId3"/>
    <p:sldId id="261" r:id="rId4"/>
    <p:sldId id="262" r:id="rId5"/>
    <p:sldId id="266" r:id="rId6"/>
    <p:sldId id="269" r:id="rId7"/>
    <p:sldId id="271" r:id="rId8"/>
    <p:sldId id="277" r:id="rId9"/>
    <p:sldId id="278" r:id="rId10"/>
    <p:sldId id="282" r:id="rId11"/>
    <p:sldId id="289" r:id="rId12"/>
    <p:sldId id="290" r:id="rId13"/>
    <p:sldId id="298" r:id="rId14"/>
    <p:sldId id="291" r:id="rId15"/>
    <p:sldId id="286" r:id="rId16"/>
    <p:sldId id="283" r:id="rId17"/>
    <p:sldId id="284" r:id="rId18"/>
    <p:sldId id="295" r:id="rId19"/>
    <p:sldId id="292" r:id="rId20"/>
    <p:sldId id="296" r:id="rId21"/>
    <p:sldId id="293" r:id="rId22"/>
    <p:sldId id="294" r:id="rId23"/>
    <p:sldId id="285" r:id="rId2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27"/>
  </p:normalViewPr>
  <p:slideViewPr>
    <p:cSldViewPr snapToGrid="0" snapToObjects="1">
      <p:cViewPr>
        <p:scale>
          <a:sx n="70" d="100"/>
          <a:sy n="70" d="100"/>
        </p:scale>
        <p:origin x="1082" y="4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linc\Desktop\cRY-sortag\Changfan_Data_Dark-light%20differenc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linc\Desktop\CRY-sortag\Final%20Results-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Dark-light difference</a:t>
            </a:r>
          </a:p>
        </c:rich>
      </c:tx>
      <c:layout>
        <c:manualLayout>
          <c:xMode val="edge"/>
          <c:yMode val="edge"/>
          <c:x val="0.32554855643044617"/>
          <c:y val="3.106796116504854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1]Sheet1!$J$41</c:f>
              <c:strCache>
                <c:ptCount val="1"/>
                <c:pt idx="0">
                  <c:v>Dark-light differenc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[1]Sheet1!$F$42,[1]Sheet1!$F$46,[1]Sheet1!$F$50)</c:f>
                <c:numCache>
                  <c:formatCode>General</c:formatCode>
                  <c:ptCount val="3"/>
                  <c:pt idx="0">
                    <c:v>0.39258655601443387</c:v>
                  </c:pt>
                  <c:pt idx="1">
                    <c:v>0.12435629297356553</c:v>
                  </c:pt>
                  <c:pt idx="2">
                    <c:v>2.0808289362204187E-2</c:v>
                  </c:pt>
                </c:numCache>
              </c:numRef>
            </c:plus>
            <c:minus>
              <c:numRef>
                <c:f>([1]Sheet1!$F$42,[1]Sheet1!$F$46,[1]Sheet1!$F$50)</c:f>
                <c:numCache>
                  <c:formatCode>General</c:formatCode>
                  <c:ptCount val="3"/>
                  <c:pt idx="0">
                    <c:v>0.39258655601443387</c:v>
                  </c:pt>
                  <c:pt idx="1">
                    <c:v>0.12435629297356553</c:v>
                  </c:pt>
                  <c:pt idx="2">
                    <c:v>2.0808289362204187E-2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Sheet1!$I$42:$I$44</c:f>
              <c:strCache>
                <c:ptCount val="3"/>
                <c:pt idx="0">
                  <c:v>WT</c:v>
                </c:pt>
                <c:pt idx="1">
                  <c:v>CRY-sortag</c:v>
                </c:pt>
                <c:pt idx="2">
                  <c:v>CRY-delta</c:v>
                </c:pt>
              </c:strCache>
            </c:strRef>
          </c:cat>
          <c:val>
            <c:numRef>
              <c:f>[1]Sheet1!$J$42:$J$44</c:f>
              <c:numCache>
                <c:formatCode>General</c:formatCode>
                <c:ptCount val="3"/>
                <c:pt idx="0">
                  <c:v>2.7864150861918016</c:v>
                </c:pt>
                <c:pt idx="1">
                  <c:v>1.5918094595564938</c:v>
                </c:pt>
                <c:pt idx="2">
                  <c:v>1.0520768893371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47-419D-AC06-37C7307EDA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67741519"/>
        <c:axId val="2067588479"/>
      </c:barChart>
      <c:scatterChart>
        <c:scatterStyle val="lineMarker"/>
        <c:varyColors val="0"/>
        <c:ser>
          <c:idx val="1"/>
          <c:order val="1"/>
          <c:tx>
            <c:v>Series2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bg1"/>
              </a:solidFill>
              <a:ln w="31750">
                <a:solidFill>
                  <a:schemeClr val="tx1"/>
                </a:solidFill>
              </a:ln>
              <a:effectLst/>
            </c:spPr>
          </c:marker>
          <c:yVal>
            <c:numRef>
              <c:f>Sheet1!$C$20:$E$20</c:f>
              <c:numCache>
                <c:formatCode>General</c:formatCode>
                <c:ptCount val="3"/>
                <c:pt idx="0">
                  <c:v>3.1033233213671969</c:v>
                </c:pt>
                <c:pt idx="1">
                  <c:v>1.4634270292056732</c:v>
                </c:pt>
                <c:pt idx="2">
                  <c:v>1.06541283474866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A47-419D-AC06-37C7307EDAC0}"/>
            </c:ext>
          </c:extLst>
        </c:ser>
        <c:ser>
          <c:idx val="2"/>
          <c:order val="2"/>
          <c:tx>
            <c:v>Series3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bg1"/>
              </a:solidFill>
              <a:ln w="31750">
                <a:solidFill>
                  <a:schemeClr val="tx1"/>
                </a:solidFill>
              </a:ln>
              <a:effectLst/>
            </c:spPr>
          </c:marker>
          <c:yVal>
            <c:numRef>
              <c:f>Sheet1!$C$21:$E$21</c:f>
              <c:numCache>
                <c:formatCode>General</c:formatCode>
                <c:ptCount val="3"/>
                <c:pt idx="0">
                  <c:v>3.2500939847255212</c:v>
                </c:pt>
                <c:pt idx="1">
                  <c:v>1.8404781164132527</c:v>
                </c:pt>
                <c:pt idx="2">
                  <c:v>1.01126848402528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A47-419D-AC06-37C7307EDAC0}"/>
            </c:ext>
          </c:extLst>
        </c:ser>
        <c:ser>
          <c:idx val="3"/>
          <c:order val="3"/>
          <c:tx>
            <c:v>Series4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bg1"/>
              </a:solidFill>
              <a:ln w="31750">
                <a:solidFill>
                  <a:schemeClr val="tx1"/>
                </a:solidFill>
              </a:ln>
              <a:effectLst/>
            </c:spPr>
          </c:marker>
          <c:yVal>
            <c:numRef>
              <c:f>Sheet1!$C$22:$E$22</c:f>
              <c:numCache>
                <c:formatCode>General</c:formatCode>
                <c:ptCount val="3"/>
                <c:pt idx="0">
                  <c:v>2.005827952482687</c:v>
                </c:pt>
                <c:pt idx="1">
                  <c:v>1.471523233050555</c:v>
                </c:pt>
                <c:pt idx="2">
                  <c:v>1.07954934923740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A47-419D-AC06-37C7307EDA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67741519"/>
        <c:axId val="2067588479"/>
      </c:scatterChart>
      <c:catAx>
        <c:axId val="20677415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7588479"/>
        <c:crosses val="autoZero"/>
        <c:auto val="1"/>
        <c:lblAlgn val="ctr"/>
        <c:lblOffset val="100"/>
        <c:noMultiLvlLbl val="0"/>
      </c:catAx>
      <c:valAx>
        <c:axId val="20675884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77415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RY</a:t>
            </a:r>
            <a:r>
              <a:rPr lang="en-US" baseline="0"/>
              <a:t> expression level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ormalized to ladder-Figures'!$C$25</c:f>
              <c:strCache>
                <c:ptCount val="1"/>
                <c:pt idx="0">
                  <c:v>Protein level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Normalized to ladder-Figures'!$F$5,'Normalized to ladder-Figures'!$F$8,'Normalized to ladder-Figures'!$F$11)</c:f>
                <c:numCache>
                  <c:formatCode>General</c:formatCode>
                  <c:ptCount val="3"/>
                  <c:pt idx="0">
                    <c:v>0.23553245106408804</c:v>
                  </c:pt>
                  <c:pt idx="1">
                    <c:v>1.2190844011999481E-2</c:v>
                  </c:pt>
                  <c:pt idx="2">
                    <c:v>0.21504604284805454</c:v>
                  </c:pt>
                </c:numCache>
              </c:numRef>
            </c:plus>
            <c:minus>
              <c:numRef>
                <c:f>('Normalized to ladder-Figures'!$F$5,'Normalized to ladder-Figures'!$F$8,'Normalized to ladder-Figures'!$F$11)</c:f>
                <c:numCache>
                  <c:formatCode>General</c:formatCode>
                  <c:ptCount val="3"/>
                  <c:pt idx="0">
                    <c:v>0.23553245106408804</c:v>
                  </c:pt>
                  <c:pt idx="1">
                    <c:v>1.2190844011999481E-2</c:v>
                  </c:pt>
                  <c:pt idx="2">
                    <c:v>0.21504604284805454</c:v>
                  </c:pt>
                </c:numCache>
              </c:numRef>
            </c:minus>
            <c:spPr>
              <a:noFill/>
              <a:ln w="317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ormalized to ladder-Figures'!$B$26:$B$28</c:f>
              <c:strCache>
                <c:ptCount val="3"/>
                <c:pt idx="0">
                  <c:v>WT</c:v>
                </c:pt>
                <c:pt idx="1">
                  <c:v>CRY-ΔCTT</c:v>
                </c:pt>
                <c:pt idx="2">
                  <c:v>CRY-Sorttag</c:v>
                </c:pt>
              </c:strCache>
            </c:strRef>
          </c:cat>
          <c:val>
            <c:numRef>
              <c:f>'Normalized to ladder-Figures'!$C$26:$C$28</c:f>
              <c:numCache>
                <c:formatCode>General</c:formatCode>
                <c:ptCount val="3"/>
                <c:pt idx="0">
                  <c:v>1.0000000000235891</c:v>
                </c:pt>
                <c:pt idx="1">
                  <c:v>0.13308529204686015</c:v>
                </c:pt>
                <c:pt idx="2">
                  <c:v>0.83984669009627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EF-4049-B7E0-02BBF6BF69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70173023"/>
        <c:axId val="869567807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bg1"/>
              </a:solidFill>
              <a:ln w="31750">
                <a:solidFill>
                  <a:schemeClr val="tx1"/>
                </a:solidFill>
              </a:ln>
              <a:effectLst/>
            </c:spPr>
          </c:marker>
          <c:yVal>
            <c:numRef>
              <c:f>('Normalized to ladder-Figures'!$D$5,'Normalized to ladder-Figures'!$D$8,'Normalized to ladder-Figures'!$D$11)</c:f>
              <c:numCache>
                <c:formatCode>General</c:formatCode>
                <c:ptCount val="3"/>
                <c:pt idx="0">
                  <c:v>0.72160848071266148</c:v>
                </c:pt>
                <c:pt idx="1">
                  <c:v>0.11773899510816546</c:v>
                </c:pt>
                <c:pt idx="2">
                  <c:v>1.26507448162532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5EF-4049-B7E0-02BBF6BF69EA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bg1"/>
              </a:solidFill>
              <a:ln w="31750">
                <a:solidFill>
                  <a:schemeClr val="tx1"/>
                </a:solidFill>
              </a:ln>
              <a:effectLst/>
            </c:spPr>
          </c:marker>
          <c:yVal>
            <c:numRef>
              <c:f>('Normalized to ladder-Figures'!$D$6,'Normalized to ladder-Figures'!$D$9,'Normalized to ladder-Figures'!$D$12)</c:f>
              <c:numCache>
                <c:formatCode>General</c:formatCode>
                <c:ptCount val="3"/>
                <c:pt idx="0">
                  <c:v>0.81010575983921218</c:v>
                </c:pt>
                <c:pt idx="1">
                  <c:v>0.15716631700516157</c:v>
                </c:pt>
                <c:pt idx="2">
                  <c:v>0.571372292925872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5EF-4049-B7E0-02BBF6BF69EA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bg1"/>
              </a:solidFill>
              <a:ln w="31750">
                <a:solidFill>
                  <a:schemeClr val="tx1"/>
                </a:solidFill>
              </a:ln>
              <a:effectLst/>
            </c:spPr>
          </c:marker>
          <c:yVal>
            <c:numRef>
              <c:f>('Normalized to ladder-Figures'!$D$7,'Normalized to ladder-Figures'!$D$10,'Normalized to ladder-Figures'!$D$13)</c:f>
              <c:numCache>
                <c:formatCode>General</c:formatCode>
                <c:ptCount val="3"/>
                <c:pt idx="0">
                  <c:v>1.4682857595188936</c:v>
                </c:pt>
                <c:pt idx="1">
                  <c:v>0.12435056402725339</c:v>
                </c:pt>
                <c:pt idx="2">
                  <c:v>0.683093295737630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5EF-4049-B7E0-02BBF6BF69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0173023"/>
        <c:axId val="869567807"/>
      </c:scatterChart>
      <c:catAx>
        <c:axId val="8701730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9567807"/>
        <c:crosses val="autoZero"/>
        <c:auto val="1"/>
        <c:lblAlgn val="ctr"/>
        <c:lblOffset val="100"/>
        <c:noMultiLvlLbl val="0"/>
      </c:catAx>
      <c:valAx>
        <c:axId val="8695678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701730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72E611-97DD-C34B-AA80-AEC43C4038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FDCF1F-8DDE-A44C-B679-3370567D2C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A45F43-ABCC-3F4E-BCDB-70E5DA406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65277D-D859-5843-9A34-08446A032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5268B7-343C-F24F-8008-C5777E670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423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56561-4190-1244-819C-E86ED0A34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49A394-A73F-FF4A-BD18-DA734DAD43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2F983A-80FB-A24C-A616-04304EB79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408EC7-18BF-E446-92A6-792F657FA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5FC41D-C63E-FD47-8D54-09009A378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196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B8B6A6-A618-2142-AF05-4FDD4FE9D8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3908A8-4CD4-4442-B682-D27DE5C051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07A93E-F6B0-844E-AAEC-6102ED90A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05A643-87F5-284D-8235-B25FC81C6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8BBA06-DBD1-9A43-923A-0229D291E1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277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33475-D3BA-074C-A0AF-540230D50E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CA26C8-0DCD-8049-AE39-227B970C70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95CCA2-E9E2-2B4A-9FAE-E987D9F39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9512C8-FB58-1E49-8A0C-04097D367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3F5C98-15E2-D04C-8A54-34931A079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513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9E83F6-6A9A-5A4E-8BF9-F987E492C6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3A3E16-428E-2D49-95CD-129F3EA372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C527ED-385B-D444-A7F5-D3A2C4172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3F11CB-06E2-FE4C-901E-1B2DD1CB1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93BA7C-1277-284E-A08B-DA12987CA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56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043C79-999A-4B48-BAF5-50DA8EBA9D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F0835A-8433-D74F-B8CC-FE4EA10801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E1BD79-EEC6-2A44-8BF4-3F60CE83EB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367668-25D9-6142-A6AE-568F2A4F2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D76C52-5271-F84A-9ABF-7664A5B79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1A6AF1-7249-1143-A211-265446811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706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21703-9CDB-AB49-879B-C99B24C85D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A8FCAD-156B-2141-A7ED-D5053A8730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3EDE93-C3F8-9949-8266-A459BE9BF8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0767527-FA4A-964B-8625-13A0BCC61C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3F6C24D-01E3-B547-9AFE-47D78F9ABC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B8907C-B1B5-A742-9286-79F8BE00EB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355CC5-6217-A548-8C93-B58222474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A9534D-F7EB-6B4F-ACBA-9B18718E73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7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43204C-CB18-6944-A179-1F44D562BE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003437-45BF-D346-8523-C849AB640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83F2CF4-F6AF-E045-9B3B-5678B442ED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F42BB75-B20B-D147-92F2-3FE1F8EB17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870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757CD3-B58C-EE44-88BD-CFB43420C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FB460B-722D-A742-9D65-AB58929FB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783DF9-1606-DA4B-8C0A-6730EAD9C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772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4E377-E7BD-1047-953C-8CEFEAA477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DC14E2-B01C-3245-9322-89B1034A4F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EFAE71-96FB-054D-9652-4A7A5B1699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A65B8B-9756-024D-83FC-55FEB03DD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3AE7AC-C9AA-3E4C-B99E-670A8A865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5924E-992A-5F43-931C-516B07412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377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735136-9540-1F4F-9F48-E3C62EDE9F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BDBB63-463D-7946-94A6-C4386DB60A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3E36CF-B10B-2740-BE9F-A99418E66D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9CF05B-9A1F-CA47-84F6-622EEBEEF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444B1C-2F0C-1549-95E1-82F0DD00D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CCDDD3-71CC-354F-B002-CA5FB3AEC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617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052DDC-6C7C-9E40-A350-47A559D484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2C86A6-C8C6-404E-93AC-50DD770A31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6A3924-6831-1A40-BDB9-F30271B1F8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4C316C-330A-C241-BCD4-3388E87340B5}" type="datetimeFigureOut">
              <a:rPr lang="en-US" smtClean="0"/>
              <a:t>1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30C5C3-4E2A-2146-8F06-14AAB94DF6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5A0D5A-DE75-854F-84DF-53B87EA5CC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7885B-0DF0-AE46-8510-DB8417910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624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eg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microsoft.com/office/2007/relationships/hdphoto" Target="../media/hdphoto1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7C2CCF-3295-CC4A-99D7-E9E83D895C73}"/>
              </a:ext>
            </a:extLst>
          </p:cNvPr>
          <p:cNvSpPr txBox="1"/>
          <p:nvPr/>
        </p:nvSpPr>
        <p:spPr>
          <a:xfrm>
            <a:off x="4659630" y="3382736"/>
            <a:ext cx="2480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data for figure S7, b</a:t>
            </a:r>
          </a:p>
        </p:txBody>
      </p:sp>
    </p:spTree>
    <p:extLst>
      <p:ext uri="{BB962C8B-B14F-4D97-AF65-F5344CB8AC3E}">
        <p14:creationId xmlns:p14="http://schemas.microsoft.com/office/powerpoint/2010/main" val="26469931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8D7AAE8-37E4-B64C-8D3A-E54766DC11BE}"/>
              </a:ext>
            </a:extLst>
          </p:cNvPr>
          <p:cNvSpPr txBox="1"/>
          <p:nvPr/>
        </p:nvSpPr>
        <p:spPr>
          <a:xfrm>
            <a:off x="1154430" y="2228850"/>
            <a:ext cx="2480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data for figure S7, d</a:t>
            </a:r>
          </a:p>
        </p:txBody>
      </p:sp>
    </p:spTree>
    <p:extLst>
      <p:ext uri="{BB962C8B-B14F-4D97-AF65-F5344CB8AC3E}">
        <p14:creationId xmlns:p14="http://schemas.microsoft.com/office/powerpoint/2010/main" val="62270802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600D495-F655-46B5-91CE-0BC3F0E02577}"/>
              </a:ext>
            </a:extLst>
          </p:cNvPr>
          <p:cNvSpPr txBox="1"/>
          <p:nvPr/>
        </p:nvSpPr>
        <p:spPr>
          <a:xfrm>
            <a:off x="1513159" y="756042"/>
            <a:ext cx="1115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im Rep 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7457B0B-82F2-49B4-B0D0-6BCDD739ECB9}"/>
              </a:ext>
            </a:extLst>
          </p:cNvPr>
          <p:cNvSpPr txBox="1"/>
          <p:nvPr/>
        </p:nvSpPr>
        <p:spPr>
          <a:xfrm rot="18769529">
            <a:off x="2638406" y="1547200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6D0DD3A-BE9C-403B-B01E-AA0105BC0BFF}"/>
              </a:ext>
            </a:extLst>
          </p:cNvPr>
          <p:cNvSpPr txBox="1"/>
          <p:nvPr/>
        </p:nvSpPr>
        <p:spPr>
          <a:xfrm rot="18769529">
            <a:off x="3103906" y="1568348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D6D9741-2337-49F5-9996-CCCC71582297}"/>
              </a:ext>
            </a:extLst>
          </p:cNvPr>
          <p:cNvSpPr txBox="1"/>
          <p:nvPr/>
        </p:nvSpPr>
        <p:spPr>
          <a:xfrm rot="18880991">
            <a:off x="3396995" y="1408511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42DB65-0C83-483A-96D9-36D441018D0B}"/>
              </a:ext>
            </a:extLst>
          </p:cNvPr>
          <p:cNvSpPr txBox="1"/>
          <p:nvPr/>
        </p:nvSpPr>
        <p:spPr>
          <a:xfrm rot="18823579">
            <a:off x="3832827" y="1430308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  <p:pic>
        <p:nvPicPr>
          <p:cNvPr id="16" name="Picture 15" descr="A close up of a person&#10;&#10;Description automatically generated">
            <a:extLst>
              <a:ext uri="{FF2B5EF4-FFF2-40B4-BE49-F238E27FC236}">
                <a16:creationId xmlns:a16="http://schemas.microsoft.com/office/drawing/2014/main" id="{B3CFB575-D2D1-4BC1-A538-2C277C6F5AB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89768" y="2352877"/>
            <a:ext cx="3701986" cy="381998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448148A-90CC-41FA-B891-1D6B505B35C2}"/>
              </a:ext>
            </a:extLst>
          </p:cNvPr>
          <p:cNvSpPr txBox="1"/>
          <p:nvPr/>
        </p:nvSpPr>
        <p:spPr>
          <a:xfrm>
            <a:off x="7713002" y="1206350"/>
            <a:ext cx="19512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1 Total Protein</a:t>
            </a:r>
          </a:p>
        </p:txBody>
      </p:sp>
      <p:pic>
        <p:nvPicPr>
          <p:cNvPr id="12" name="Picture 11" descr="A picture containing sitting, guitar&#10;&#10;Description automatically generated">
            <a:extLst>
              <a:ext uri="{FF2B5EF4-FFF2-40B4-BE49-F238E27FC236}">
                <a16:creationId xmlns:a16="http://schemas.microsoft.com/office/drawing/2014/main" id="{6906B9BC-D7A0-4614-83CF-B849FAC9457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945692" y="1940441"/>
            <a:ext cx="3677464" cy="417483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118289E-CD29-4D82-A90E-E1E1BF92EB06}"/>
              </a:ext>
            </a:extLst>
          </p:cNvPr>
          <p:cNvSpPr txBox="1"/>
          <p:nvPr/>
        </p:nvSpPr>
        <p:spPr>
          <a:xfrm rot="18769529">
            <a:off x="8730671" y="2103802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5CCD82E-B5AF-421F-BB57-4C28D0DA41CD}"/>
              </a:ext>
            </a:extLst>
          </p:cNvPr>
          <p:cNvSpPr txBox="1"/>
          <p:nvPr/>
        </p:nvSpPr>
        <p:spPr>
          <a:xfrm rot="18769529">
            <a:off x="9196171" y="2124950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5DB36BD-253E-4A0F-AE70-6FFACB06A956}"/>
              </a:ext>
            </a:extLst>
          </p:cNvPr>
          <p:cNvSpPr txBox="1"/>
          <p:nvPr/>
        </p:nvSpPr>
        <p:spPr>
          <a:xfrm rot="18880991">
            <a:off x="9489260" y="1965113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1ECB362-F8F6-40E5-A70B-59BE0F789358}"/>
              </a:ext>
            </a:extLst>
          </p:cNvPr>
          <p:cNvSpPr txBox="1"/>
          <p:nvPr/>
        </p:nvSpPr>
        <p:spPr>
          <a:xfrm rot="18823579">
            <a:off x="9925092" y="1986910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</p:spTree>
    <p:extLst>
      <p:ext uri="{BB962C8B-B14F-4D97-AF65-F5344CB8AC3E}">
        <p14:creationId xmlns:p14="http://schemas.microsoft.com/office/powerpoint/2010/main" val="1618682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FBF3038-B8E8-4A60-9B11-4B2BFB8E22FA}"/>
              </a:ext>
            </a:extLst>
          </p:cNvPr>
          <p:cNvSpPr txBox="1"/>
          <p:nvPr/>
        </p:nvSpPr>
        <p:spPr>
          <a:xfrm>
            <a:off x="1404730" y="515107"/>
            <a:ext cx="1115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im Rep 2</a:t>
            </a:r>
          </a:p>
        </p:txBody>
      </p:sp>
      <p:pic>
        <p:nvPicPr>
          <p:cNvPr id="6" name="Picture 5" descr="A close up of a building&#10;&#10;Description automatically generated">
            <a:extLst>
              <a:ext uri="{FF2B5EF4-FFF2-40B4-BE49-F238E27FC236}">
                <a16:creationId xmlns:a16="http://schemas.microsoft.com/office/drawing/2014/main" id="{968F86FE-233D-44B7-A90A-92CC77194B2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5442" y="2302563"/>
            <a:ext cx="5584029" cy="377075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9C793B6-6ACE-4325-ACE5-1B053F6FA12A}"/>
              </a:ext>
            </a:extLst>
          </p:cNvPr>
          <p:cNvSpPr txBox="1"/>
          <p:nvPr/>
        </p:nvSpPr>
        <p:spPr>
          <a:xfrm rot="18873034">
            <a:off x="2083709" y="1744007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C53FA6B-E826-4D0E-B3A1-509559C9F728}"/>
              </a:ext>
            </a:extLst>
          </p:cNvPr>
          <p:cNvSpPr txBox="1"/>
          <p:nvPr/>
        </p:nvSpPr>
        <p:spPr>
          <a:xfrm rot="18719185">
            <a:off x="2566629" y="1744168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FBA2BED-BEAE-46E7-BA2F-BB3D8FD28980}"/>
              </a:ext>
            </a:extLst>
          </p:cNvPr>
          <p:cNvSpPr txBox="1"/>
          <p:nvPr/>
        </p:nvSpPr>
        <p:spPr>
          <a:xfrm rot="18769529">
            <a:off x="1061398" y="1547200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E8EE72C-8E28-459E-BBB3-5A60D2AEC1F1}"/>
              </a:ext>
            </a:extLst>
          </p:cNvPr>
          <p:cNvSpPr txBox="1"/>
          <p:nvPr/>
        </p:nvSpPr>
        <p:spPr>
          <a:xfrm rot="18769529">
            <a:off x="1526898" y="1568348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67F025E-52D8-4CE8-A8AD-610770EB185D}"/>
              </a:ext>
            </a:extLst>
          </p:cNvPr>
          <p:cNvSpPr txBox="1"/>
          <p:nvPr/>
        </p:nvSpPr>
        <p:spPr>
          <a:xfrm rot="18880991">
            <a:off x="2813802" y="1483581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1A34BBB-422E-4FF0-A3F0-A1971E42D9BC}"/>
              </a:ext>
            </a:extLst>
          </p:cNvPr>
          <p:cNvSpPr txBox="1"/>
          <p:nvPr/>
        </p:nvSpPr>
        <p:spPr>
          <a:xfrm rot="18823579">
            <a:off x="3305906" y="1505378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  <p:pic>
        <p:nvPicPr>
          <p:cNvPr id="14" name="Picture 13" descr="A building covered in snow&#10;&#10;Description automatically generated">
            <a:extLst>
              <a:ext uri="{FF2B5EF4-FFF2-40B4-BE49-F238E27FC236}">
                <a16:creationId xmlns:a16="http://schemas.microsoft.com/office/drawing/2014/main" id="{2B2A2F56-246E-4BF9-8A77-BDC4C250213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6557135" y="2302562"/>
            <a:ext cx="5256730" cy="377075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68962EB7-003E-4ADD-8F86-70D4359956E5}"/>
              </a:ext>
            </a:extLst>
          </p:cNvPr>
          <p:cNvSpPr txBox="1"/>
          <p:nvPr/>
        </p:nvSpPr>
        <p:spPr>
          <a:xfrm>
            <a:off x="5376160" y="6315887"/>
            <a:ext cx="2019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fferent exposures</a:t>
            </a:r>
          </a:p>
        </p:txBody>
      </p:sp>
    </p:spTree>
    <p:extLst>
      <p:ext uri="{BB962C8B-B14F-4D97-AF65-F5344CB8AC3E}">
        <p14:creationId xmlns:p14="http://schemas.microsoft.com/office/powerpoint/2010/main" val="165504397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36898D-A1A7-40D6-B5D6-10F5E7154C3D}"/>
              </a:ext>
            </a:extLst>
          </p:cNvPr>
          <p:cNvSpPr txBox="1"/>
          <p:nvPr/>
        </p:nvSpPr>
        <p:spPr>
          <a:xfrm>
            <a:off x="1404730" y="515107"/>
            <a:ext cx="19512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2 Total Protei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0F130B-8B1E-4C6A-8EC0-3927376290F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02973" y="1520186"/>
            <a:ext cx="4457313" cy="43004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61C9E95-128D-437E-B4FC-068C35E4E7C2}"/>
              </a:ext>
            </a:extLst>
          </p:cNvPr>
          <p:cNvSpPr txBox="1"/>
          <p:nvPr/>
        </p:nvSpPr>
        <p:spPr>
          <a:xfrm rot="18873034">
            <a:off x="2083709" y="1744007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4878F5C-0029-413A-81D5-4311054199FE}"/>
              </a:ext>
            </a:extLst>
          </p:cNvPr>
          <p:cNvSpPr txBox="1"/>
          <p:nvPr/>
        </p:nvSpPr>
        <p:spPr>
          <a:xfrm rot="18719185">
            <a:off x="2566629" y="1744168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5F1ABF-A126-4A77-82A7-176019AF9136}"/>
              </a:ext>
            </a:extLst>
          </p:cNvPr>
          <p:cNvSpPr txBox="1"/>
          <p:nvPr/>
        </p:nvSpPr>
        <p:spPr>
          <a:xfrm rot="18769529">
            <a:off x="1061398" y="1547200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438780-7D7E-4746-AC76-B545084775E8}"/>
              </a:ext>
            </a:extLst>
          </p:cNvPr>
          <p:cNvSpPr txBox="1"/>
          <p:nvPr/>
        </p:nvSpPr>
        <p:spPr>
          <a:xfrm rot="18769529">
            <a:off x="1526898" y="1568348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C9689A-0159-4234-98C3-9C8EE010F2EA}"/>
              </a:ext>
            </a:extLst>
          </p:cNvPr>
          <p:cNvSpPr txBox="1"/>
          <p:nvPr/>
        </p:nvSpPr>
        <p:spPr>
          <a:xfrm rot="18880991">
            <a:off x="2813802" y="1483581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A9F369-4FCF-40FC-8DC3-958ACB022A61}"/>
              </a:ext>
            </a:extLst>
          </p:cNvPr>
          <p:cNvSpPr txBox="1"/>
          <p:nvPr/>
        </p:nvSpPr>
        <p:spPr>
          <a:xfrm rot="18823579">
            <a:off x="3305906" y="1505378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</p:spTree>
    <p:extLst>
      <p:ext uri="{BB962C8B-B14F-4D97-AF65-F5344CB8AC3E}">
        <p14:creationId xmlns:p14="http://schemas.microsoft.com/office/powerpoint/2010/main" val="350498662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DC7C9CA6-8100-4E17-913B-C79940D3F543}"/>
              </a:ext>
            </a:extLst>
          </p:cNvPr>
          <p:cNvSpPr txBox="1"/>
          <p:nvPr/>
        </p:nvSpPr>
        <p:spPr>
          <a:xfrm>
            <a:off x="789687" y="712689"/>
            <a:ext cx="11151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im Rep 3</a:t>
            </a:r>
          </a:p>
        </p:txBody>
      </p:sp>
      <p:pic>
        <p:nvPicPr>
          <p:cNvPr id="14" name="Picture 13" descr="A picture containing sitting, photo, covered, train&#10;&#10;Description automatically generated">
            <a:extLst>
              <a:ext uri="{FF2B5EF4-FFF2-40B4-BE49-F238E27FC236}">
                <a16:creationId xmlns:a16="http://schemas.microsoft.com/office/drawing/2014/main" id="{5FEE98B1-E8A3-4994-9091-7746D0A433B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9696" y="2309318"/>
            <a:ext cx="5219113" cy="368833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0ECDDAD-F1D3-46E4-AD64-8E9C8B30C078}"/>
              </a:ext>
            </a:extLst>
          </p:cNvPr>
          <p:cNvSpPr txBox="1"/>
          <p:nvPr/>
        </p:nvSpPr>
        <p:spPr>
          <a:xfrm rot="18873034">
            <a:off x="1807717" y="1730574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796D365-A37A-43FA-831A-B0738D405B87}"/>
              </a:ext>
            </a:extLst>
          </p:cNvPr>
          <p:cNvSpPr txBox="1"/>
          <p:nvPr/>
        </p:nvSpPr>
        <p:spPr>
          <a:xfrm rot="18719185">
            <a:off x="2290637" y="1730735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AFAC57F-245B-4C3C-BDBA-725DB3B906E8}"/>
              </a:ext>
            </a:extLst>
          </p:cNvPr>
          <p:cNvSpPr txBox="1"/>
          <p:nvPr/>
        </p:nvSpPr>
        <p:spPr>
          <a:xfrm rot="18769529">
            <a:off x="785406" y="1533767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DB321E6-6252-4483-823E-B294E6389657}"/>
              </a:ext>
            </a:extLst>
          </p:cNvPr>
          <p:cNvSpPr txBox="1"/>
          <p:nvPr/>
        </p:nvSpPr>
        <p:spPr>
          <a:xfrm rot="18769529">
            <a:off x="1250906" y="1554915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628A98-C193-4A0E-B82A-CAB4C64346CB}"/>
              </a:ext>
            </a:extLst>
          </p:cNvPr>
          <p:cNvSpPr txBox="1"/>
          <p:nvPr/>
        </p:nvSpPr>
        <p:spPr>
          <a:xfrm rot="18880991">
            <a:off x="2537810" y="1470148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21DA5D4-4EBD-45F7-9D1B-DD1AC8B8DBF7}"/>
              </a:ext>
            </a:extLst>
          </p:cNvPr>
          <p:cNvSpPr txBox="1"/>
          <p:nvPr/>
        </p:nvSpPr>
        <p:spPr>
          <a:xfrm rot="18823579">
            <a:off x="3029914" y="1491945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  <p:pic>
        <p:nvPicPr>
          <p:cNvPr id="21" name="Picture 20" descr="A picture containing game&#10;&#10;Description automatically generated">
            <a:extLst>
              <a:ext uri="{FF2B5EF4-FFF2-40B4-BE49-F238E27FC236}">
                <a16:creationId xmlns:a16="http://schemas.microsoft.com/office/drawing/2014/main" id="{EE18FAC9-0045-4AFB-AB8D-7FCF3882F34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393627" y="2491949"/>
            <a:ext cx="4962130" cy="347472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B3E949C-4E48-4DB3-A166-9CD98F759D2E}"/>
              </a:ext>
            </a:extLst>
          </p:cNvPr>
          <p:cNvSpPr txBox="1"/>
          <p:nvPr/>
        </p:nvSpPr>
        <p:spPr>
          <a:xfrm>
            <a:off x="7101655" y="511773"/>
            <a:ext cx="2057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tal Protein  Rep 3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F10BC8E-797C-4509-B0A6-50B1967B8017}"/>
              </a:ext>
            </a:extLst>
          </p:cNvPr>
          <p:cNvSpPr txBox="1"/>
          <p:nvPr/>
        </p:nvSpPr>
        <p:spPr>
          <a:xfrm rot="18873034">
            <a:off x="7735372" y="2338043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40F45F6-7F3E-4550-9977-21DF4331992B}"/>
              </a:ext>
            </a:extLst>
          </p:cNvPr>
          <p:cNvSpPr txBox="1"/>
          <p:nvPr/>
        </p:nvSpPr>
        <p:spPr>
          <a:xfrm rot="18719185">
            <a:off x="8218292" y="2338204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25F882E-C2D5-49D1-BEF3-AB410F4224F6}"/>
              </a:ext>
            </a:extLst>
          </p:cNvPr>
          <p:cNvSpPr txBox="1"/>
          <p:nvPr/>
        </p:nvSpPr>
        <p:spPr>
          <a:xfrm rot="18769529">
            <a:off x="6713061" y="2141236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884376E-6451-49DF-8959-C768A2BC363A}"/>
              </a:ext>
            </a:extLst>
          </p:cNvPr>
          <p:cNvSpPr txBox="1"/>
          <p:nvPr/>
        </p:nvSpPr>
        <p:spPr>
          <a:xfrm rot="18769529">
            <a:off x="7178561" y="2162384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CD269B9-67BF-424F-AD66-5564DB522018}"/>
              </a:ext>
            </a:extLst>
          </p:cNvPr>
          <p:cNvSpPr txBox="1"/>
          <p:nvPr/>
        </p:nvSpPr>
        <p:spPr>
          <a:xfrm rot="18880991">
            <a:off x="8465465" y="2077617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431B9DC-1EBE-4957-A361-DB8970392B09}"/>
              </a:ext>
            </a:extLst>
          </p:cNvPr>
          <p:cNvSpPr txBox="1"/>
          <p:nvPr/>
        </p:nvSpPr>
        <p:spPr>
          <a:xfrm rot="18823579">
            <a:off x="8957569" y="2099414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</p:spTree>
    <p:extLst>
      <p:ext uri="{BB962C8B-B14F-4D97-AF65-F5344CB8AC3E}">
        <p14:creationId xmlns:p14="http://schemas.microsoft.com/office/powerpoint/2010/main" val="257089612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F84490F-B9E1-2E43-A528-1CB5BC5C0769}"/>
              </a:ext>
            </a:extLst>
          </p:cNvPr>
          <p:cNvGraphicFramePr>
            <a:graphicFrameLocks noGrp="1"/>
          </p:cNvGraphicFramePr>
          <p:nvPr/>
        </p:nvGraphicFramePr>
        <p:xfrm>
          <a:off x="2381250" y="2114550"/>
          <a:ext cx="7429500" cy="26308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5500">
                  <a:extLst>
                    <a:ext uri="{9D8B030D-6E8A-4147-A177-3AD203B41FA5}">
                      <a16:colId xmlns:a16="http://schemas.microsoft.com/office/drawing/2014/main" val="2894942094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1223817349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531582226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1722936660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155341110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1420112840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1254717552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2987825614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169269650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I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946361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2946912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21279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Dark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Ligh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tandard devia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E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 value (two component t-test for correlated samples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414172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T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749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03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6377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122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682899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T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21481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7742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WT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57129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1966197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RY-</a:t>
                      </a:r>
                      <a:r>
                        <a:rPr lang="el-GR" sz="1100" u="none" strike="noStrike">
                          <a:effectLst/>
                        </a:rPr>
                        <a:t>Δ</a:t>
                      </a:r>
                      <a:r>
                        <a:rPr lang="en-US" sz="1100" u="none" strike="noStrike">
                          <a:effectLst/>
                        </a:rPr>
                        <a:t>CTT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96927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62105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3915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784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126315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RY-</a:t>
                      </a:r>
                      <a:r>
                        <a:rPr lang="el-GR" sz="1100" u="none" strike="noStrike">
                          <a:effectLst/>
                        </a:rPr>
                        <a:t>Δ</a:t>
                      </a:r>
                      <a:r>
                        <a:rPr lang="en-US" sz="1100" u="none" strike="noStrike">
                          <a:effectLst/>
                        </a:rPr>
                        <a:t>CTT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09097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8326131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172649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RY-Sorttag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7145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53455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88597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445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506667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RY-Sorttag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07213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7922609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RY-Sorttag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04129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412668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9388086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06734B8-12DB-1F48-BC33-AF947CD2F5A1}"/>
              </a:ext>
            </a:extLst>
          </p:cNvPr>
          <p:cNvSpPr txBox="1"/>
          <p:nvPr/>
        </p:nvSpPr>
        <p:spPr>
          <a:xfrm>
            <a:off x="1154430" y="2228850"/>
            <a:ext cx="2473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data for figure S7, e</a:t>
            </a:r>
          </a:p>
        </p:txBody>
      </p:sp>
    </p:spTree>
    <p:extLst>
      <p:ext uri="{BB962C8B-B14F-4D97-AF65-F5344CB8AC3E}">
        <p14:creationId xmlns:p14="http://schemas.microsoft.com/office/powerpoint/2010/main" val="170550200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36898D-A1A7-40D6-B5D6-10F5E7154C3D}"/>
              </a:ext>
            </a:extLst>
          </p:cNvPr>
          <p:cNvSpPr txBox="1"/>
          <p:nvPr/>
        </p:nvSpPr>
        <p:spPr>
          <a:xfrm>
            <a:off x="1404730" y="515107"/>
            <a:ext cx="107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Rep 1</a:t>
            </a:r>
          </a:p>
        </p:txBody>
      </p:sp>
      <p:pic>
        <p:nvPicPr>
          <p:cNvPr id="6" name="Picture 5" descr="A close up of a piano&#10;&#10;Description automatically generated">
            <a:extLst>
              <a:ext uri="{FF2B5EF4-FFF2-40B4-BE49-F238E27FC236}">
                <a16:creationId xmlns:a16="http://schemas.microsoft.com/office/drawing/2014/main" id="{68633947-C669-41EB-A7CC-E9342CD456C8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04639" y="2316867"/>
            <a:ext cx="4935468" cy="368620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88147D0-F158-437E-8F2C-678DA64F563A}"/>
              </a:ext>
            </a:extLst>
          </p:cNvPr>
          <p:cNvSpPr txBox="1"/>
          <p:nvPr/>
        </p:nvSpPr>
        <p:spPr>
          <a:xfrm rot="18873034">
            <a:off x="4467697" y="1783832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82E6905-5C83-451D-80FA-98B2D00F1EE5}"/>
              </a:ext>
            </a:extLst>
          </p:cNvPr>
          <p:cNvSpPr txBox="1"/>
          <p:nvPr/>
        </p:nvSpPr>
        <p:spPr>
          <a:xfrm rot="18719185">
            <a:off x="4937924" y="1783670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E0B71C0-7E49-40ED-B99D-79472AD019E2}"/>
              </a:ext>
            </a:extLst>
          </p:cNvPr>
          <p:cNvSpPr txBox="1"/>
          <p:nvPr/>
        </p:nvSpPr>
        <p:spPr>
          <a:xfrm rot="18769529">
            <a:off x="2638406" y="1547200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04E14D9-4488-4408-99A8-7EE4DFA62E2B}"/>
              </a:ext>
            </a:extLst>
          </p:cNvPr>
          <p:cNvSpPr txBox="1"/>
          <p:nvPr/>
        </p:nvSpPr>
        <p:spPr>
          <a:xfrm rot="18769529">
            <a:off x="3103906" y="1568348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CDBD662-C459-4304-AEDA-D838A2B0BA33}"/>
              </a:ext>
            </a:extLst>
          </p:cNvPr>
          <p:cNvSpPr txBox="1"/>
          <p:nvPr/>
        </p:nvSpPr>
        <p:spPr>
          <a:xfrm rot="18880991">
            <a:off x="3340723" y="1408511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70B81A0-6ED1-47BF-B020-7460917C0E03}"/>
              </a:ext>
            </a:extLst>
          </p:cNvPr>
          <p:cNvSpPr txBox="1"/>
          <p:nvPr/>
        </p:nvSpPr>
        <p:spPr>
          <a:xfrm rot="18823579">
            <a:off x="3832827" y="1430308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  <p:pic>
        <p:nvPicPr>
          <p:cNvPr id="20" name="Picture 19" descr="A picture containing photo, sitting, snow, door&#10;&#10;Description automatically generated">
            <a:extLst>
              <a:ext uri="{FF2B5EF4-FFF2-40B4-BE49-F238E27FC236}">
                <a16:creationId xmlns:a16="http://schemas.microsoft.com/office/drawing/2014/main" id="{7666A1B3-105A-4C67-9B3E-AEBFD82FFF6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944846" y="2316867"/>
            <a:ext cx="5486822" cy="3792386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7C41B5B-2AB6-457D-9406-5042215D2D98}"/>
              </a:ext>
            </a:extLst>
          </p:cNvPr>
          <p:cNvSpPr txBox="1"/>
          <p:nvPr/>
        </p:nvSpPr>
        <p:spPr>
          <a:xfrm>
            <a:off x="5376160" y="6315887"/>
            <a:ext cx="2019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fferent exposures</a:t>
            </a:r>
          </a:p>
        </p:txBody>
      </p:sp>
    </p:spTree>
    <p:extLst>
      <p:ext uri="{BB962C8B-B14F-4D97-AF65-F5344CB8AC3E}">
        <p14:creationId xmlns:p14="http://schemas.microsoft.com/office/powerpoint/2010/main" val="59021334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36898D-A1A7-40D6-B5D6-10F5E7154C3D}"/>
              </a:ext>
            </a:extLst>
          </p:cNvPr>
          <p:cNvSpPr txBox="1"/>
          <p:nvPr/>
        </p:nvSpPr>
        <p:spPr>
          <a:xfrm>
            <a:off x="1404730" y="515107"/>
            <a:ext cx="19512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1 Total Protein</a:t>
            </a:r>
          </a:p>
        </p:txBody>
      </p:sp>
      <p:pic>
        <p:nvPicPr>
          <p:cNvPr id="3" name="Picture 2" descr="A picture containing sitting, guitar&#10;&#10;Description automatically generated">
            <a:extLst>
              <a:ext uri="{FF2B5EF4-FFF2-40B4-BE49-F238E27FC236}">
                <a16:creationId xmlns:a16="http://schemas.microsoft.com/office/drawing/2014/main" id="{9296D11B-F9BC-434B-9349-D67819B38DD9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6389" y="1470991"/>
            <a:ext cx="6066719" cy="453201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3E36816-EF5A-430E-B4B9-3CBEABD0952B}"/>
              </a:ext>
            </a:extLst>
          </p:cNvPr>
          <p:cNvSpPr txBox="1"/>
          <p:nvPr/>
        </p:nvSpPr>
        <p:spPr>
          <a:xfrm rot="18873034">
            <a:off x="4467697" y="1956108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5CD1C80-EF14-45E8-87ED-EA650FD52863}"/>
              </a:ext>
            </a:extLst>
          </p:cNvPr>
          <p:cNvSpPr txBox="1"/>
          <p:nvPr/>
        </p:nvSpPr>
        <p:spPr>
          <a:xfrm rot="18719185">
            <a:off x="4937924" y="1955946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A6C533-2216-4285-9E2D-27DBB557E5FA}"/>
              </a:ext>
            </a:extLst>
          </p:cNvPr>
          <p:cNvSpPr txBox="1"/>
          <p:nvPr/>
        </p:nvSpPr>
        <p:spPr>
          <a:xfrm rot="18769529">
            <a:off x="2638406" y="1719476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27A3C9-3E8D-456C-8490-AE22FBDD21E3}"/>
              </a:ext>
            </a:extLst>
          </p:cNvPr>
          <p:cNvSpPr txBox="1"/>
          <p:nvPr/>
        </p:nvSpPr>
        <p:spPr>
          <a:xfrm rot="18769529">
            <a:off x="3103906" y="1740624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C30795-1426-4194-AD3A-D2E728797D8A}"/>
              </a:ext>
            </a:extLst>
          </p:cNvPr>
          <p:cNvSpPr txBox="1"/>
          <p:nvPr/>
        </p:nvSpPr>
        <p:spPr>
          <a:xfrm rot="18880991">
            <a:off x="3340723" y="1580787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33613E6-9585-43F4-AB67-1015F9186ED6}"/>
              </a:ext>
            </a:extLst>
          </p:cNvPr>
          <p:cNvSpPr txBox="1"/>
          <p:nvPr/>
        </p:nvSpPr>
        <p:spPr>
          <a:xfrm rot="18823579">
            <a:off x="3832827" y="1602584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</p:spTree>
    <p:extLst>
      <p:ext uri="{BB962C8B-B14F-4D97-AF65-F5344CB8AC3E}">
        <p14:creationId xmlns:p14="http://schemas.microsoft.com/office/powerpoint/2010/main" val="4252921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36898D-A1A7-40D6-B5D6-10F5E7154C3D}"/>
              </a:ext>
            </a:extLst>
          </p:cNvPr>
          <p:cNvSpPr txBox="1"/>
          <p:nvPr/>
        </p:nvSpPr>
        <p:spPr>
          <a:xfrm>
            <a:off x="1404730" y="515107"/>
            <a:ext cx="107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Rep 2</a:t>
            </a:r>
          </a:p>
        </p:txBody>
      </p:sp>
      <p:pic>
        <p:nvPicPr>
          <p:cNvPr id="3" name="Picture 2" descr="A picture containing skiing, snow, slope, flying&#10;&#10;Description automatically generated">
            <a:extLst>
              <a:ext uri="{FF2B5EF4-FFF2-40B4-BE49-F238E27FC236}">
                <a16:creationId xmlns:a16="http://schemas.microsoft.com/office/drawing/2014/main" id="{289AC2B0-3CFB-4ACF-BD0F-303601A909D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4377" y="2366974"/>
            <a:ext cx="5881623" cy="3948913"/>
          </a:xfrm>
          <a:prstGeom prst="rect">
            <a:avLst/>
          </a:prstGeom>
        </p:spPr>
      </p:pic>
      <p:pic>
        <p:nvPicPr>
          <p:cNvPr id="8" name="Picture 7" descr="A picture containing snow, person, standing, cat&#10;&#10;Description automatically generated">
            <a:extLst>
              <a:ext uri="{FF2B5EF4-FFF2-40B4-BE49-F238E27FC236}">
                <a16:creationId xmlns:a16="http://schemas.microsoft.com/office/drawing/2014/main" id="{4CBFB799-4B2D-4B2B-9A41-494C3398BC4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6386020" y="2366975"/>
            <a:ext cx="5706794" cy="394891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81C72F1-3B69-4859-8AAB-EB6BA7E2D580}"/>
              </a:ext>
            </a:extLst>
          </p:cNvPr>
          <p:cNvSpPr txBox="1"/>
          <p:nvPr/>
        </p:nvSpPr>
        <p:spPr>
          <a:xfrm>
            <a:off x="5376160" y="6315887"/>
            <a:ext cx="2019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fferent exposur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EF171A-BD45-4A0D-9160-8543E8F9D16B}"/>
              </a:ext>
            </a:extLst>
          </p:cNvPr>
          <p:cNvSpPr txBox="1"/>
          <p:nvPr/>
        </p:nvSpPr>
        <p:spPr>
          <a:xfrm rot="18873034">
            <a:off x="1709505" y="3092688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9BF51AE-7ABF-4193-95D3-590DD7EC43B6}"/>
              </a:ext>
            </a:extLst>
          </p:cNvPr>
          <p:cNvSpPr txBox="1"/>
          <p:nvPr/>
        </p:nvSpPr>
        <p:spPr>
          <a:xfrm rot="18719185">
            <a:off x="2192425" y="3092849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9F6BDF-F0A5-4C21-B573-9B451AB7674C}"/>
              </a:ext>
            </a:extLst>
          </p:cNvPr>
          <p:cNvSpPr txBox="1"/>
          <p:nvPr/>
        </p:nvSpPr>
        <p:spPr>
          <a:xfrm rot="18769529">
            <a:off x="687194" y="2895881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3901217-71F3-4D08-9AAD-EBC37FDA8E85}"/>
              </a:ext>
            </a:extLst>
          </p:cNvPr>
          <p:cNvSpPr txBox="1"/>
          <p:nvPr/>
        </p:nvSpPr>
        <p:spPr>
          <a:xfrm rot="18769529">
            <a:off x="1152694" y="2917029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D1A1046-DB19-485E-B320-044F3D5E0067}"/>
              </a:ext>
            </a:extLst>
          </p:cNvPr>
          <p:cNvSpPr txBox="1"/>
          <p:nvPr/>
        </p:nvSpPr>
        <p:spPr>
          <a:xfrm rot="18880991">
            <a:off x="2439598" y="2832262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36981EC-7EFF-49FB-BB9B-0D1E8FBB9FC5}"/>
              </a:ext>
            </a:extLst>
          </p:cNvPr>
          <p:cNvSpPr txBox="1"/>
          <p:nvPr/>
        </p:nvSpPr>
        <p:spPr>
          <a:xfrm rot="18823579">
            <a:off x="2931702" y="2854059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</p:spTree>
    <p:extLst>
      <p:ext uri="{BB962C8B-B14F-4D97-AF65-F5344CB8AC3E}">
        <p14:creationId xmlns:p14="http://schemas.microsoft.com/office/powerpoint/2010/main" val="32279904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EE58553-1494-A043-B49D-2247DE8F42A4}"/>
              </a:ext>
            </a:extLst>
          </p:cNvPr>
          <p:cNvSpPr txBox="1"/>
          <p:nvPr/>
        </p:nvSpPr>
        <p:spPr>
          <a:xfrm>
            <a:off x="59865" y="68032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 1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26D754C-6ABF-41A6-94ED-376284422F31}"/>
              </a:ext>
            </a:extLst>
          </p:cNvPr>
          <p:cNvGrpSpPr/>
          <p:nvPr/>
        </p:nvGrpSpPr>
        <p:grpSpPr>
          <a:xfrm>
            <a:off x="260335" y="1190066"/>
            <a:ext cx="5698317" cy="4782672"/>
            <a:chOff x="3780174" y="641815"/>
            <a:chExt cx="5698317" cy="4782672"/>
          </a:xfrm>
        </p:grpSpPr>
        <p:pic>
          <p:nvPicPr>
            <p:cNvPr id="4" name="Picture 3" descr="A close up of a building&#10;&#10;Description automatically generated">
              <a:extLst>
                <a:ext uri="{FF2B5EF4-FFF2-40B4-BE49-F238E27FC236}">
                  <a16:creationId xmlns:a16="http://schemas.microsoft.com/office/drawing/2014/main" id="{D9E17202-9F84-4553-85BA-F6471F8463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54779" y="1433512"/>
              <a:ext cx="3981693" cy="399097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98A200A-9538-4694-A8AB-89DCE58656A7}"/>
                </a:ext>
              </a:extLst>
            </p:cNvPr>
            <p:cNvSpPr txBox="1"/>
            <p:nvPr/>
          </p:nvSpPr>
          <p:spPr>
            <a:xfrm rot="19809635">
              <a:off x="3780174" y="825358"/>
              <a:ext cx="13511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lysate-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D828F9D-362A-49D8-9E58-55C52F75CC1E}"/>
                </a:ext>
              </a:extLst>
            </p:cNvPr>
            <p:cNvSpPr txBox="1"/>
            <p:nvPr/>
          </p:nvSpPr>
          <p:spPr>
            <a:xfrm rot="19809635">
              <a:off x="4388038" y="825360"/>
              <a:ext cx="13062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lysate-L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6543DDC-B83B-4A19-9462-8CB258941205}"/>
                </a:ext>
              </a:extLst>
            </p:cNvPr>
            <p:cNvSpPr txBox="1"/>
            <p:nvPr/>
          </p:nvSpPr>
          <p:spPr>
            <a:xfrm rot="19809635">
              <a:off x="4631828" y="788939"/>
              <a:ext cx="1989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lysate-D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9DA3A44-7D5B-4477-8CF5-4B3E94D3474D}"/>
                </a:ext>
              </a:extLst>
            </p:cNvPr>
            <p:cNvSpPr txBox="1"/>
            <p:nvPr/>
          </p:nvSpPr>
          <p:spPr>
            <a:xfrm rot="19809635">
              <a:off x="5248340" y="710539"/>
              <a:ext cx="1944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lysate-L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FDE89CB-0FEE-4D41-9173-3832B77BD5BB}"/>
                </a:ext>
              </a:extLst>
            </p:cNvPr>
            <p:cNvSpPr txBox="1"/>
            <p:nvPr/>
          </p:nvSpPr>
          <p:spPr>
            <a:xfrm rot="19809635">
              <a:off x="5861898" y="836527"/>
              <a:ext cx="16871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pulldown-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C93395A-7A9B-4C08-A22C-E9E37D4A8808}"/>
                </a:ext>
              </a:extLst>
            </p:cNvPr>
            <p:cNvSpPr txBox="1"/>
            <p:nvPr/>
          </p:nvSpPr>
          <p:spPr>
            <a:xfrm rot="19809635">
              <a:off x="6346147" y="819371"/>
              <a:ext cx="16423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pulldown-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F98B230-FF5A-4713-B394-F3BCD417125E}"/>
                </a:ext>
              </a:extLst>
            </p:cNvPr>
            <p:cNvSpPr txBox="1"/>
            <p:nvPr/>
          </p:nvSpPr>
          <p:spPr>
            <a:xfrm rot="19809635">
              <a:off x="6670806" y="669442"/>
              <a:ext cx="23255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D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0A83738-6CE7-4D23-9CD8-060E5C1C052F}"/>
                </a:ext>
              </a:extLst>
            </p:cNvPr>
            <p:cNvSpPr txBox="1"/>
            <p:nvPr/>
          </p:nvSpPr>
          <p:spPr>
            <a:xfrm rot="19809635">
              <a:off x="7197802" y="641815"/>
              <a:ext cx="22806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30F4443-B957-4767-BDED-7FC15DAB993E}"/>
                </a:ext>
              </a:extLst>
            </p:cNvPr>
            <p:cNvSpPr txBox="1"/>
            <p:nvPr/>
          </p:nvSpPr>
          <p:spPr>
            <a:xfrm>
              <a:off x="8164317" y="2562444"/>
              <a:ext cx="541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</a:t>
              </a:r>
            </a:p>
          </p:txBody>
        </p:sp>
      </p:grpSp>
      <p:pic>
        <p:nvPicPr>
          <p:cNvPr id="15" name="Content Placeholder 4" descr="Graffiti on the side of a building&#10;&#10;Description automatically generated">
            <a:extLst>
              <a:ext uri="{FF2B5EF4-FFF2-40B4-BE49-F238E27FC236}">
                <a16:creationId xmlns:a16="http://schemas.microsoft.com/office/drawing/2014/main" id="{F920C0B0-EA73-4C9C-BC21-6B2374BA3BB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12184" y="1559859"/>
            <a:ext cx="4530387" cy="456996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94C0836-1687-481A-AA30-F5E56587F65B}"/>
              </a:ext>
            </a:extLst>
          </p:cNvPr>
          <p:cNvSpPr txBox="1"/>
          <p:nvPr/>
        </p:nvSpPr>
        <p:spPr>
          <a:xfrm rot="19809635">
            <a:off x="6414504" y="878865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3A65DE4-FA99-473F-AAA3-B87746B51810}"/>
              </a:ext>
            </a:extLst>
          </p:cNvPr>
          <p:cNvSpPr txBox="1"/>
          <p:nvPr/>
        </p:nvSpPr>
        <p:spPr>
          <a:xfrm rot="19809635">
            <a:off x="7022368" y="878867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DCC0E41-DBC9-4C11-BA01-BD6F7C8A5D92}"/>
              </a:ext>
            </a:extLst>
          </p:cNvPr>
          <p:cNvSpPr txBox="1"/>
          <p:nvPr/>
        </p:nvSpPr>
        <p:spPr>
          <a:xfrm rot="19809635">
            <a:off x="7266158" y="842446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AD14453-3E9C-4E37-AE48-98A725974B29}"/>
              </a:ext>
            </a:extLst>
          </p:cNvPr>
          <p:cNvSpPr txBox="1"/>
          <p:nvPr/>
        </p:nvSpPr>
        <p:spPr>
          <a:xfrm rot="19809635">
            <a:off x="7882670" y="764046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B4A7B48-E1E6-4B04-8A00-28F7054E8E6A}"/>
              </a:ext>
            </a:extLst>
          </p:cNvPr>
          <p:cNvSpPr txBox="1"/>
          <p:nvPr/>
        </p:nvSpPr>
        <p:spPr>
          <a:xfrm rot="19809635">
            <a:off x="8496228" y="890034"/>
            <a:ext cx="1687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pulldown-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B8C3067-E99B-4FD2-9035-B1A18F899B8B}"/>
              </a:ext>
            </a:extLst>
          </p:cNvPr>
          <p:cNvSpPr txBox="1"/>
          <p:nvPr/>
        </p:nvSpPr>
        <p:spPr>
          <a:xfrm rot="19809635">
            <a:off x="8980477" y="872878"/>
            <a:ext cx="1642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pulldown-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054E392-3514-4255-9749-143E8A360AF4}"/>
              </a:ext>
            </a:extLst>
          </p:cNvPr>
          <p:cNvSpPr txBox="1"/>
          <p:nvPr/>
        </p:nvSpPr>
        <p:spPr>
          <a:xfrm rot="19809635">
            <a:off x="9305136" y="722949"/>
            <a:ext cx="2325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pulldown-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BEA2474-D952-494A-BA8C-E0B8EEDE7532}"/>
              </a:ext>
            </a:extLst>
          </p:cNvPr>
          <p:cNvSpPr txBox="1"/>
          <p:nvPr/>
        </p:nvSpPr>
        <p:spPr>
          <a:xfrm rot="19809635">
            <a:off x="9832132" y="695322"/>
            <a:ext cx="2280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pulldown-L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9430CF1-E621-49BE-9DE3-D8203281D827}"/>
              </a:ext>
            </a:extLst>
          </p:cNvPr>
          <p:cNvSpPr txBox="1"/>
          <p:nvPr/>
        </p:nvSpPr>
        <p:spPr>
          <a:xfrm>
            <a:off x="6305378" y="6344398"/>
            <a:ext cx="1618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exposed longer</a:t>
            </a:r>
          </a:p>
        </p:txBody>
      </p:sp>
    </p:spTree>
    <p:extLst>
      <p:ext uri="{BB962C8B-B14F-4D97-AF65-F5344CB8AC3E}">
        <p14:creationId xmlns:p14="http://schemas.microsoft.com/office/powerpoint/2010/main" val="429030005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036898D-A1A7-40D6-B5D6-10F5E7154C3D}"/>
              </a:ext>
            </a:extLst>
          </p:cNvPr>
          <p:cNvSpPr txBox="1"/>
          <p:nvPr/>
        </p:nvSpPr>
        <p:spPr>
          <a:xfrm>
            <a:off x="1404730" y="515107"/>
            <a:ext cx="19512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 2 Total Protei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0F130B-8B1E-4C6A-8EC0-3927376290F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1858" y="1542133"/>
            <a:ext cx="4842911" cy="46725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614E47F-2198-4615-A4E8-6722C77AC4C8}"/>
              </a:ext>
            </a:extLst>
          </p:cNvPr>
          <p:cNvSpPr txBox="1"/>
          <p:nvPr/>
        </p:nvSpPr>
        <p:spPr>
          <a:xfrm rot="18873034">
            <a:off x="1749262" y="1953001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61C1A19-6A4A-4221-8128-9D6F2B1D74E1}"/>
              </a:ext>
            </a:extLst>
          </p:cNvPr>
          <p:cNvSpPr txBox="1"/>
          <p:nvPr/>
        </p:nvSpPr>
        <p:spPr>
          <a:xfrm rot="18719185">
            <a:off x="2232182" y="1953162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4B50771-D4C9-44D6-B540-BDEF7F6AAD09}"/>
              </a:ext>
            </a:extLst>
          </p:cNvPr>
          <p:cNvSpPr txBox="1"/>
          <p:nvPr/>
        </p:nvSpPr>
        <p:spPr>
          <a:xfrm rot="18769529">
            <a:off x="647508" y="1794126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33A023C-9A6B-40AF-84BA-657E6A05339C}"/>
              </a:ext>
            </a:extLst>
          </p:cNvPr>
          <p:cNvSpPr txBox="1"/>
          <p:nvPr/>
        </p:nvSpPr>
        <p:spPr>
          <a:xfrm rot="18769529">
            <a:off x="1192451" y="1777342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9C59F44-AAF1-4CE9-B9A1-99E77CD695F2}"/>
              </a:ext>
            </a:extLst>
          </p:cNvPr>
          <p:cNvSpPr txBox="1"/>
          <p:nvPr/>
        </p:nvSpPr>
        <p:spPr>
          <a:xfrm rot="18880991">
            <a:off x="2479355" y="1454036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DF37C4-F174-473A-B32C-D4270FBC861A}"/>
              </a:ext>
            </a:extLst>
          </p:cNvPr>
          <p:cNvSpPr txBox="1"/>
          <p:nvPr/>
        </p:nvSpPr>
        <p:spPr>
          <a:xfrm rot="18823579">
            <a:off x="2971459" y="1475833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</p:spTree>
    <p:extLst>
      <p:ext uri="{BB962C8B-B14F-4D97-AF65-F5344CB8AC3E}">
        <p14:creationId xmlns:p14="http://schemas.microsoft.com/office/powerpoint/2010/main" val="290908574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928F8E-E5B0-4278-8423-98F2E75F0CC1}"/>
              </a:ext>
            </a:extLst>
          </p:cNvPr>
          <p:cNvSpPr txBox="1"/>
          <p:nvPr/>
        </p:nvSpPr>
        <p:spPr>
          <a:xfrm>
            <a:off x="901209" y="217232"/>
            <a:ext cx="107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Rep 3</a:t>
            </a:r>
          </a:p>
        </p:txBody>
      </p:sp>
      <p:pic>
        <p:nvPicPr>
          <p:cNvPr id="6" name="Picture 5" descr="A picture containing person, airplane, cat, plane&#10;&#10;Description automatically generated">
            <a:extLst>
              <a:ext uri="{FF2B5EF4-FFF2-40B4-BE49-F238E27FC236}">
                <a16:creationId xmlns:a16="http://schemas.microsoft.com/office/drawing/2014/main" id="{B1B005F4-F4C8-4C30-AA3B-8BDECE6D973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31520" y="2261537"/>
            <a:ext cx="5388936" cy="3976366"/>
          </a:xfrm>
          <a:prstGeom prst="rect">
            <a:avLst/>
          </a:prstGeom>
        </p:spPr>
      </p:pic>
      <p:pic>
        <p:nvPicPr>
          <p:cNvPr id="8" name="Picture 7" descr="A picture containing building, photo, sitting, old&#10;&#10;Description automatically generated">
            <a:extLst>
              <a:ext uri="{FF2B5EF4-FFF2-40B4-BE49-F238E27FC236}">
                <a16:creationId xmlns:a16="http://schemas.microsoft.com/office/drawing/2014/main" id="{A56EEC1E-42D3-45D8-87D1-D0F1C1B8699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157852" y="2232893"/>
            <a:ext cx="5424366" cy="397636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FC57A1C-4C0D-4362-A661-05C6A840B02D}"/>
              </a:ext>
            </a:extLst>
          </p:cNvPr>
          <p:cNvSpPr txBox="1"/>
          <p:nvPr/>
        </p:nvSpPr>
        <p:spPr>
          <a:xfrm>
            <a:off x="5268058" y="6346062"/>
            <a:ext cx="2019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fferent exposur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A2BB97-5A73-4B64-AA82-0BCFDECE0E15}"/>
              </a:ext>
            </a:extLst>
          </p:cNvPr>
          <p:cNvSpPr txBox="1"/>
          <p:nvPr/>
        </p:nvSpPr>
        <p:spPr>
          <a:xfrm rot="18873034">
            <a:off x="2268014" y="1532992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2961F8-4D97-4F2D-9296-19811F8FC4D1}"/>
              </a:ext>
            </a:extLst>
          </p:cNvPr>
          <p:cNvSpPr txBox="1"/>
          <p:nvPr/>
        </p:nvSpPr>
        <p:spPr>
          <a:xfrm rot="18719185">
            <a:off x="2750934" y="1533153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A0CBF0F-DB5B-4CB4-8554-29C811032FBC}"/>
              </a:ext>
            </a:extLst>
          </p:cNvPr>
          <p:cNvSpPr txBox="1"/>
          <p:nvPr/>
        </p:nvSpPr>
        <p:spPr>
          <a:xfrm rot="18769529">
            <a:off x="1245703" y="1336185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CF019F7-FE0E-41C5-8F6D-3A2580AD8E72}"/>
              </a:ext>
            </a:extLst>
          </p:cNvPr>
          <p:cNvSpPr txBox="1"/>
          <p:nvPr/>
        </p:nvSpPr>
        <p:spPr>
          <a:xfrm rot="18769529">
            <a:off x="1711203" y="1357333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A29DFE1-3278-495F-8B81-7E16AD0509F9}"/>
              </a:ext>
            </a:extLst>
          </p:cNvPr>
          <p:cNvSpPr txBox="1"/>
          <p:nvPr/>
        </p:nvSpPr>
        <p:spPr>
          <a:xfrm rot="18880991">
            <a:off x="2998107" y="1272566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07D7EA8-EC07-456D-90A3-0861FEE06E90}"/>
              </a:ext>
            </a:extLst>
          </p:cNvPr>
          <p:cNvSpPr txBox="1"/>
          <p:nvPr/>
        </p:nvSpPr>
        <p:spPr>
          <a:xfrm rot="18823579">
            <a:off x="3490211" y="1294363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</p:spTree>
    <p:extLst>
      <p:ext uri="{BB962C8B-B14F-4D97-AF65-F5344CB8AC3E}">
        <p14:creationId xmlns:p14="http://schemas.microsoft.com/office/powerpoint/2010/main" val="346185621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game&#10;&#10;Description automatically generated">
            <a:extLst>
              <a:ext uri="{FF2B5EF4-FFF2-40B4-BE49-F238E27FC236}">
                <a16:creationId xmlns:a16="http://schemas.microsoft.com/office/drawing/2014/main" id="{A5604647-1880-4592-8F20-B7173382F95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6618" y="2152865"/>
            <a:ext cx="5271483" cy="369134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4FBFB53-905D-4E1E-BDAB-5917148B4370}"/>
              </a:ext>
            </a:extLst>
          </p:cNvPr>
          <p:cNvSpPr txBox="1"/>
          <p:nvPr/>
        </p:nvSpPr>
        <p:spPr>
          <a:xfrm>
            <a:off x="1404730" y="515107"/>
            <a:ext cx="2004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Rep 3 Total Prote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583680A-490E-4A4F-B451-7501E59F2399}"/>
              </a:ext>
            </a:extLst>
          </p:cNvPr>
          <p:cNvSpPr txBox="1"/>
          <p:nvPr/>
        </p:nvSpPr>
        <p:spPr>
          <a:xfrm rot="18873034">
            <a:off x="2027559" y="2032514"/>
            <a:ext cx="9324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03856E6-66DB-4E0A-9B78-94D335908333}"/>
              </a:ext>
            </a:extLst>
          </p:cNvPr>
          <p:cNvSpPr txBox="1"/>
          <p:nvPr/>
        </p:nvSpPr>
        <p:spPr>
          <a:xfrm rot="18719185">
            <a:off x="2510479" y="2032675"/>
            <a:ext cx="910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RY </a:t>
            </a:r>
            <a:r>
              <a:rPr lang="el-GR" dirty="0"/>
              <a:t>Δ</a:t>
            </a:r>
            <a:r>
              <a:rPr lang="en-US" dirty="0"/>
              <a:t> 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2160343-1FB7-4732-9178-4F7476179147}"/>
              </a:ext>
            </a:extLst>
          </p:cNvPr>
          <p:cNvSpPr txBox="1"/>
          <p:nvPr/>
        </p:nvSpPr>
        <p:spPr>
          <a:xfrm rot="18769529">
            <a:off x="1005248" y="1835707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939742B-6E34-4B9A-A842-2AB6DEBD4B30}"/>
              </a:ext>
            </a:extLst>
          </p:cNvPr>
          <p:cNvSpPr txBox="1"/>
          <p:nvPr/>
        </p:nvSpPr>
        <p:spPr>
          <a:xfrm rot="18769529">
            <a:off x="1470748" y="1856855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9D2B37-4117-4E99-929A-6AED360DF412}"/>
              </a:ext>
            </a:extLst>
          </p:cNvPr>
          <p:cNvSpPr txBox="1"/>
          <p:nvPr/>
        </p:nvSpPr>
        <p:spPr>
          <a:xfrm rot="18880991">
            <a:off x="2757652" y="1772088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306AB2-F930-4679-A9D3-C9044C10CFE0}"/>
              </a:ext>
            </a:extLst>
          </p:cNvPr>
          <p:cNvSpPr txBox="1"/>
          <p:nvPr/>
        </p:nvSpPr>
        <p:spPr>
          <a:xfrm rot="18823579">
            <a:off x="3249756" y="1793885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</p:spTree>
    <p:extLst>
      <p:ext uri="{BB962C8B-B14F-4D97-AF65-F5344CB8AC3E}">
        <p14:creationId xmlns:p14="http://schemas.microsoft.com/office/powerpoint/2010/main" val="383342562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9DB7CB17-2B8C-AD46-B510-718FA9DD5806}"/>
              </a:ext>
            </a:extLst>
          </p:cNvPr>
          <p:cNvGraphicFramePr>
            <a:graphicFrameLocks/>
          </p:cNvGraphicFramePr>
          <p:nvPr/>
        </p:nvGraphicFramePr>
        <p:xfrm>
          <a:off x="1524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BF6E78F-F6F7-CF4B-8DA5-89CFBD3B971E}"/>
              </a:ext>
            </a:extLst>
          </p:cNvPr>
          <p:cNvSpPr txBox="1"/>
          <p:nvPr/>
        </p:nvSpPr>
        <p:spPr>
          <a:xfrm>
            <a:off x="7415213" y="1314450"/>
            <a:ext cx="32883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rmalized to ladder on each gel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D80ED7CE-1B00-AE4E-94C8-D86E964415A4}"/>
              </a:ext>
            </a:extLst>
          </p:cNvPr>
          <p:cNvGraphicFramePr>
            <a:graphicFrameLocks noGrp="1"/>
          </p:cNvGraphicFramePr>
          <p:nvPr/>
        </p:nvGraphicFramePr>
        <p:xfrm>
          <a:off x="7415213" y="2720975"/>
          <a:ext cx="2476500" cy="330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76500">
                  <a:extLst>
                    <a:ext uri="{9D8B030D-6E8A-4147-A177-3AD203B41FA5}">
                      <a16:colId xmlns:a16="http://schemas.microsoft.com/office/drawing/2014/main" val="2689120161"/>
                    </a:ext>
                  </a:extLst>
                </a:gridCol>
              </a:tblGrid>
              <a:tr h="330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000" u="none" strike="noStrike" dirty="0">
                          <a:effectLst/>
                        </a:rPr>
                        <a:t>One way </a:t>
                      </a:r>
                      <a:r>
                        <a:rPr lang="en-US" sz="2000" u="none" strike="noStrike" dirty="0" err="1">
                          <a:effectLst/>
                        </a:rPr>
                        <a:t>Anova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86094072"/>
                  </a:ext>
                </a:extLst>
              </a:tr>
            </a:tbl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id="{7F83A4CB-4056-7C49-B7B3-42ED6A79D35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75500" y="3429000"/>
            <a:ext cx="3492500" cy="24003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5841400-8027-B24A-AAA3-B68833E38596}"/>
              </a:ext>
            </a:extLst>
          </p:cNvPr>
          <p:cNvSpPr txBox="1"/>
          <p:nvPr/>
        </p:nvSpPr>
        <p:spPr>
          <a:xfrm>
            <a:off x="1268730" y="5292090"/>
            <a:ext cx="241976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wo-tailed Paired t-test,</a:t>
            </a:r>
          </a:p>
          <a:p>
            <a:r>
              <a:rPr lang="en-US" dirty="0"/>
              <a:t>M1 vs M2, 0.068216</a:t>
            </a:r>
          </a:p>
          <a:p>
            <a:r>
              <a:rPr lang="en-US" dirty="0"/>
              <a:t>M1 vs M3, 0.715305</a:t>
            </a:r>
          </a:p>
          <a:p>
            <a:r>
              <a:rPr lang="en-US" dirty="0"/>
              <a:t>M2 vs M3, 0.087723</a:t>
            </a:r>
          </a:p>
        </p:txBody>
      </p:sp>
    </p:spTree>
    <p:extLst>
      <p:ext uri="{BB962C8B-B14F-4D97-AF65-F5344CB8AC3E}">
        <p14:creationId xmlns:p14="http://schemas.microsoft.com/office/powerpoint/2010/main" val="4940233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F862327-335B-4BCF-BD7F-218135AD82A4}"/>
              </a:ext>
            </a:extLst>
          </p:cNvPr>
          <p:cNvGrpSpPr/>
          <p:nvPr/>
        </p:nvGrpSpPr>
        <p:grpSpPr>
          <a:xfrm>
            <a:off x="2426677" y="922803"/>
            <a:ext cx="4543078" cy="4932806"/>
            <a:chOff x="2426677" y="922803"/>
            <a:chExt cx="4543078" cy="4932806"/>
          </a:xfrm>
        </p:grpSpPr>
        <p:pic>
          <p:nvPicPr>
            <p:cNvPr id="5" name="Picture 4" descr="A picture containing sitting, front, light, close&#10;&#10;Description automatically generated">
              <a:extLst>
                <a:ext uri="{FF2B5EF4-FFF2-40B4-BE49-F238E27FC236}">
                  <a16:creationId xmlns:a16="http://schemas.microsoft.com/office/drawing/2014/main" id="{2E4698E4-A848-464A-9C0A-E5A50F7AA6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58308" y="1742341"/>
              <a:ext cx="2110153" cy="411326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6BA00BE-114D-634F-B39E-C385E5DC309C}"/>
                </a:ext>
              </a:extLst>
            </p:cNvPr>
            <p:cNvSpPr txBox="1"/>
            <p:nvPr/>
          </p:nvSpPr>
          <p:spPr>
            <a:xfrm rot="19809635">
              <a:off x="3353162" y="1117515"/>
              <a:ext cx="16871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pulldown-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45F0C7C-5113-D241-A408-F87B443BA624}"/>
                </a:ext>
              </a:extLst>
            </p:cNvPr>
            <p:cNvSpPr txBox="1"/>
            <p:nvPr/>
          </p:nvSpPr>
          <p:spPr>
            <a:xfrm rot="19809635">
              <a:off x="3837411" y="1100359"/>
              <a:ext cx="16423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pulldown-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E75A1B8-BA77-924D-93CF-B4A6C7D9F18F}"/>
                </a:ext>
              </a:extLst>
            </p:cNvPr>
            <p:cNvSpPr txBox="1"/>
            <p:nvPr/>
          </p:nvSpPr>
          <p:spPr>
            <a:xfrm rot="19809635">
              <a:off x="4162070" y="950430"/>
              <a:ext cx="23255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D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A78B771-31D5-2640-A1D6-A040D7A8C457}"/>
                </a:ext>
              </a:extLst>
            </p:cNvPr>
            <p:cNvSpPr txBox="1"/>
            <p:nvPr/>
          </p:nvSpPr>
          <p:spPr>
            <a:xfrm rot="19809635">
              <a:off x="4689066" y="922803"/>
              <a:ext cx="22806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9F062FF-DAFB-BF44-8DDA-C32684BCFFA1}"/>
                </a:ext>
              </a:extLst>
            </p:cNvPr>
            <p:cNvSpPr txBox="1"/>
            <p:nvPr/>
          </p:nvSpPr>
          <p:spPr>
            <a:xfrm>
              <a:off x="2426677" y="2379785"/>
              <a:ext cx="5517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I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966528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A574BE-41F9-4F49-BDEA-7C42065831D9}"/>
              </a:ext>
            </a:extLst>
          </p:cNvPr>
          <p:cNvSpPr txBox="1"/>
          <p:nvPr/>
        </p:nvSpPr>
        <p:spPr>
          <a:xfrm>
            <a:off x="159173" y="123614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 2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55A97C5-9616-4594-AA78-4EE345AB27F4}"/>
              </a:ext>
            </a:extLst>
          </p:cNvPr>
          <p:cNvGrpSpPr/>
          <p:nvPr/>
        </p:nvGrpSpPr>
        <p:grpSpPr>
          <a:xfrm>
            <a:off x="1768902" y="1040410"/>
            <a:ext cx="4145319" cy="3599447"/>
            <a:chOff x="1726569" y="646710"/>
            <a:chExt cx="4145319" cy="3599447"/>
          </a:xfrm>
        </p:grpSpPr>
        <p:pic>
          <p:nvPicPr>
            <p:cNvPr id="5" name="Picture 4" descr="A picture containing sitting, small, water, front&#10;&#10;Description automatically generated">
              <a:extLst>
                <a:ext uri="{FF2B5EF4-FFF2-40B4-BE49-F238E27FC236}">
                  <a16:creationId xmlns:a16="http://schemas.microsoft.com/office/drawing/2014/main" id="{3374A9FD-330F-46A9-A3D9-5C0B9D1227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415209" y="1327703"/>
              <a:ext cx="636340" cy="2918454"/>
            </a:xfrm>
            <a:prstGeom prst="rect">
              <a:avLst/>
            </a:prstGeom>
          </p:spPr>
        </p:pic>
        <p:pic>
          <p:nvPicPr>
            <p:cNvPr id="6" name="Picture 5" descr="A picture containing building, sitting, dirty, small&#10;&#10;Description automatically generated">
              <a:extLst>
                <a:ext uri="{FF2B5EF4-FFF2-40B4-BE49-F238E27FC236}">
                  <a16:creationId xmlns:a16="http://schemas.microsoft.com/office/drawing/2014/main" id="{22945400-2763-4B17-912D-C625250993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04860" y="1327703"/>
              <a:ext cx="636339" cy="291844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D934B76-D988-48AD-91D1-B535FCF17436}"/>
                </a:ext>
              </a:extLst>
            </p:cNvPr>
            <p:cNvSpPr txBox="1"/>
            <p:nvPr/>
          </p:nvSpPr>
          <p:spPr>
            <a:xfrm rot="19809635">
              <a:off x="2204812" y="646710"/>
              <a:ext cx="13112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T lysate-D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7AF633C-0B8A-4D25-AEC2-0E8FBAC01F80}"/>
                </a:ext>
              </a:extLst>
            </p:cNvPr>
            <p:cNvSpPr txBox="1"/>
            <p:nvPr/>
          </p:nvSpPr>
          <p:spPr>
            <a:xfrm rot="19809635">
              <a:off x="2681513" y="646710"/>
              <a:ext cx="12663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T lysate-L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2D940D9-890D-4124-A904-7B625A6602E2}"/>
                </a:ext>
              </a:extLst>
            </p:cNvPr>
            <p:cNvSpPr txBox="1"/>
            <p:nvPr/>
          </p:nvSpPr>
          <p:spPr>
            <a:xfrm rot="19809635">
              <a:off x="3794366" y="657876"/>
              <a:ext cx="1644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T Pulldown-D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2FF880A-62C1-4D00-9CD9-5D6BB70FF012}"/>
                </a:ext>
              </a:extLst>
            </p:cNvPr>
            <p:cNvSpPr txBox="1"/>
            <p:nvPr/>
          </p:nvSpPr>
          <p:spPr>
            <a:xfrm rot="19809635">
              <a:off x="4269462" y="657876"/>
              <a:ext cx="16024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T pulldown-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441C563-1399-4405-90F7-7A1C2607C0CC}"/>
                </a:ext>
              </a:extLst>
            </p:cNvPr>
            <p:cNvSpPr txBox="1"/>
            <p:nvPr/>
          </p:nvSpPr>
          <p:spPr>
            <a:xfrm>
              <a:off x="1726569" y="2602259"/>
              <a:ext cx="541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1B91341B-753F-4AFD-BB3F-639D76240198}"/>
              </a:ext>
            </a:extLst>
          </p:cNvPr>
          <p:cNvGrpSpPr/>
          <p:nvPr/>
        </p:nvGrpSpPr>
        <p:grpSpPr>
          <a:xfrm>
            <a:off x="6742889" y="589116"/>
            <a:ext cx="4644631" cy="4395618"/>
            <a:chOff x="1227257" y="646710"/>
            <a:chExt cx="4644631" cy="4395618"/>
          </a:xfrm>
        </p:grpSpPr>
        <p:pic>
          <p:nvPicPr>
            <p:cNvPr id="13" name="Picture 12" descr="A picture containing building, snow, covered, photo&#10;&#10;Description automatically generated">
              <a:extLst>
                <a:ext uri="{FF2B5EF4-FFF2-40B4-BE49-F238E27FC236}">
                  <a16:creationId xmlns:a16="http://schemas.microsoft.com/office/drawing/2014/main" id="{637E78D0-A658-4625-BC36-1B7C2B82C7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17035" y="1307824"/>
              <a:ext cx="785191" cy="3734504"/>
            </a:xfrm>
            <a:prstGeom prst="rect">
              <a:avLst/>
            </a:prstGeom>
          </p:spPr>
        </p:pic>
        <p:pic>
          <p:nvPicPr>
            <p:cNvPr id="14" name="Picture 13" descr="A picture containing sitting, table, counter, kitchen&#10;&#10;Description automatically generated">
              <a:extLst>
                <a:ext uri="{FF2B5EF4-FFF2-40B4-BE49-F238E27FC236}">
                  <a16:creationId xmlns:a16="http://schemas.microsoft.com/office/drawing/2014/main" id="{3F28CE12-A3CC-4B49-80F3-DCE0566DFE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06687" y="1337798"/>
              <a:ext cx="1182756" cy="370453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4CC2627-BD4C-42AC-BD0C-0D118EEE6838}"/>
                </a:ext>
              </a:extLst>
            </p:cNvPr>
            <p:cNvSpPr txBox="1"/>
            <p:nvPr/>
          </p:nvSpPr>
          <p:spPr>
            <a:xfrm rot="19809635">
              <a:off x="2204812" y="646710"/>
              <a:ext cx="13112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T lysate-D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882B41C-FA70-40A3-B9DA-9315FF22BD45}"/>
                </a:ext>
              </a:extLst>
            </p:cNvPr>
            <p:cNvSpPr txBox="1"/>
            <p:nvPr/>
          </p:nvSpPr>
          <p:spPr>
            <a:xfrm rot="19809635">
              <a:off x="2681513" y="646710"/>
              <a:ext cx="12663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T lysate-L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8CEA72B-6A03-446C-95AD-6797072D101B}"/>
                </a:ext>
              </a:extLst>
            </p:cNvPr>
            <p:cNvSpPr txBox="1"/>
            <p:nvPr/>
          </p:nvSpPr>
          <p:spPr>
            <a:xfrm rot="19809635">
              <a:off x="3794366" y="657876"/>
              <a:ext cx="1644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T Pulldown-D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BA5010C-48A7-4455-8A40-5C463B7C0181}"/>
                </a:ext>
              </a:extLst>
            </p:cNvPr>
            <p:cNvSpPr txBox="1"/>
            <p:nvPr/>
          </p:nvSpPr>
          <p:spPr>
            <a:xfrm rot="19809635">
              <a:off x="4269462" y="657876"/>
              <a:ext cx="16024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T pulldown-L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B7CDABA-FC15-4265-9C07-F4FF84120A90}"/>
                </a:ext>
              </a:extLst>
            </p:cNvPr>
            <p:cNvSpPr txBox="1"/>
            <p:nvPr/>
          </p:nvSpPr>
          <p:spPr>
            <a:xfrm>
              <a:off x="1227257" y="2343842"/>
              <a:ext cx="5341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i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492066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008250B-52AF-9149-A4BD-A916B07E6D2E}"/>
              </a:ext>
            </a:extLst>
          </p:cNvPr>
          <p:cNvSpPr txBox="1"/>
          <p:nvPr/>
        </p:nvSpPr>
        <p:spPr>
          <a:xfrm>
            <a:off x="176107" y="51647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 3</a:t>
            </a:r>
          </a:p>
        </p:txBody>
      </p:sp>
      <p:pic>
        <p:nvPicPr>
          <p:cNvPr id="3" name="Picture 2" descr="A close up of a building&#10;&#10;Description automatically generated">
            <a:extLst>
              <a:ext uri="{FF2B5EF4-FFF2-40B4-BE49-F238E27FC236}">
                <a16:creationId xmlns:a16="http://schemas.microsoft.com/office/drawing/2014/main" id="{46EDA7FF-84CC-41B8-8E60-CF361DF6EA9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38346" y="1623685"/>
            <a:ext cx="2401824" cy="3862388"/>
          </a:xfrm>
          <a:prstGeom prst="rect">
            <a:avLst/>
          </a:prstGeom>
        </p:spPr>
      </p:pic>
      <p:pic>
        <p:nvPicPr>
          <p:cNvPr id="4" name="Picture 3" descr="A close up of a fence&#10;&#10;Description automatically generated">
            <a:extLst>
              <a:ext uri="{FF2B5EF4-FFF2-40B4-BE49-F238E27FC236}">
                <a16:creationId xmlns:a16="http://schemas.microsoft.com/office/drawing/2014/main" id="{501DBDCF-F99E-44AA-8A82-6C3A5FF8E91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85842" y="1627918"/>
            <a:ext cx="2302677" cy="386238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8CC3D96-4185-4E2E-8BD9-22E5E851961C}"/>
              </a:ext>
            </a:extLst>
          </p:cNvPr>
          <p:cNvSpPr txBox="1"/>
          <p:nvPr/>
        </p:nvSpPr>
        <p:spPr>
          <a:xfrm>
            <a:off x="118534" y="3535204"/>
            <a:ext cx="1074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-delta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869F255B-1CE1-4098-808C-EC0EAC6BC503}"/>
              </a:ext>
            </a:extLst>
          </p:cNvPr>
          <p:cNvCxnSpPr>
            <a:cxnSpLocks/>
          </p:cNvCxnSpPr>
          <p:nvPr/>
        </p:nvCxnSpPr>
        <p:spPr>
          <a:xfrm>
            <a:off x="1139855" y="3734139"/>
            <a:ext cx="275522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CCF686C2-0F5B-4F07-8C3E-A91D627C278B}"/>
              </a:ext>
            </a:extLst>
          </p:cNvPr>
          <p:cNvSpPr txBox="1"/>
          <p:nvPr/>
        </p:nvSpPr>
        <p:spPr>
          <a:xfrm rot="19809635">
            <a:off x="1500776" y="1125165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4A316B-7347-4DD0-BF97-AE747D773DDB}"/>
              </a:ext>
            </a:extLst>
          </p:cNvPr>
          <p:cNvSpPr txBox="1"/>
          <p:nvPr/>
        </p:nvSpPr>
        <p:spPr>
          <a:xfrm rot="19809635">
            <a:off x="1940263" y="1179454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EBBB34-05D8-4999-BF4E-54AB123E39E1}"/>
              </a:ext>
            </a:extLst>
          </p:cNvPr>
          <p:cNvSpPr txBox="1"/>
          <p:nvPr/>
        </p:nvSpPr>
        <p:spPr>
          <a:xfrm rot="19809635">
            <a:off x="2182960" y="1143808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ECC02D4-1ECD-4A6F-B766-7EFBECB94599}"/>
              </a:ext>
            </a:extLst>
          </p:cNvPr>
          <p:cNvSpPr txBox="1"/>
          <p:nvPr/>
        </p:nvSpPr>
        <p:spPr>
          <a:xfrm rot="19809635">
            <a:off x="2566613" y="1136331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17BD599-712A-4D0B-B1AA-220B87FFDB75}"/>
              </a:ext>
            </a:extLst>
          </p:cNvPr>
          <p:cNvSpPr txBox="1"/>
          <p:nvPr/>
        </p:nvSpPr>
        <p:spPr>
          <a:xfrm>
            <a:off x="1036009" y="496753"/>
            <a:ext cx="763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ysat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43255FD-12F1-4583-8654-CF2C264DFEF0}"/>
              </a:ext>
            </a:extLst>
          </p:cNvPr>
          <p:cNvSpPr txBox="1"/>
          <p:nvPr/>
        </p:nvSpPr>
        <p:spPr>
          <a:xfrm>
            <a:off x="4085842" y="500986"/>
            <a:ext cx="1060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lldow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A3B9A34-F8A7-4EA8-84AA-9A9C3D08FFED}"/>
              </a:ext>
            </a:extLst>
          </p:cNvPr>
          <p:cNvSpPr txBox="1"/>
          <p:nvPr/>
        </p:nvSpPr>
        <p:spPr>
          <a:xfrm rot="19809635">
            <a:off x="2848243" y="1156047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FA0E183-B665-4CEA-82F1-E08C736004E3}"/>
              </a:ext>
            </a:extLst>
          </p:cNvPr>
          <p:cNvSpPr txBox="1"/>
          <p:nvPr/>
        </p:nvSpPr>
        <p:spPr>
          <a:xfrm rot="19809635">
            <a:off x="3251361" y="1125165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E3F23AB-64DA-49B0-9F91-A44C81140A5F}"/>
              </a:ext>
            </a:extLst>
          </p:cNvPr>
          <p:cNvSpPr txBox="1"/>
          <p:nvPr/>
        </p:nvSpPr>
        <p:spPr>
          <a:xfrm rot="19809635">
            <a:off x="4173062" y="1077807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CD61C4-4C6A-47DB-AC57-CF60943EA612}"/>
              </a:ext>
            </a:extLst>
          </p:cNvPr>
          <p:cNvSpPr txBox="1"/>
          <p:nvPr/>
        </p:nvSpPr>
        <p:spPr>
          <a:xfrm rot="19809635">
            <a:off x="4612549" y="1132096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00ACBAB-AFF1-4364-BEE9-F42E112F6209}"/>
              </a:ext>
            </a:extLst>
          </p:cNvPr>
          <p:cNvSpPr txBox="1"/>
          <p:nvPr/>
        </p:nvSpPr>
        <p:spPr>
          <a:xfrm rot="19809635">
            <a:off x="4855246" y="1096450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04F97D8-5918-4D23-9617-A51AFD8E30A7}"/>
              </a:ext>
            </a:extLst>
          </p:cNvPr>
          <p:cNvSpPr txBox="1"/>
          <p:nvPr/>
        </p:nvSpPr>
        <p:spPr>
          <a:xfrm rot="19809635">
            <a:off x="5238899" y="1088973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E13F0E2-8762-48B8-8BD2-2C26BF7DC5B3}"/>
              </a:ext>
            </a:extLst>
          </p:cNvPr>
          <p:cNvSpPr txBox="1"/>
          <p:nvPr/>
        </p:nvSpPr>
        <p:spPr>
          <a:xfrm rot="19809635">
            <a:off x="5520529" y="1108689"/>
            <a:ext cx="444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57748A2-8E09-48EC-92EE-910BAAC13D91}"/>
              </a:ext>
            </a:extLst>
          </p:cNvPr>
          <p:cNvSpPr txBox="1"/>
          <p:nvPr/>
        </p:nvSpPr>
        <p:spPr>
          <a:xfrm rot="19809635">
            <a:off x="5923647" y="1077807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3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E86FBEAE-9504-4D91-A64E-A58FEEABA3D5}"/>
              </a:ext>
            </a:extLst>
          </p:cNvPr>
          <p:cNvGrpSpPr/>
          <p:nvPr/>
        </p:nvGrpSpPr>
        <p:grpSpPr>
          <a:xfrm>
            <a:off x="6727016" y="991741"/>
            <a:ext cx="2941144" cy="4135600"/>
            <a:chOff x="1414408" y="588396"/>
            <a:chExt cx="2941144" cy="4135600"/>
          </a:xfrm>
        </p:grpSpPr>
        <p:pic>
          <p:nvPicPr>
            <p:cNvPr id="23" name="Picture 22" descr="A close up of an object&#10;&#10;Description automatically generated">
              <a:extLst>
                <a:ext uri="{FF2B5EF4-FFF2-40B4-BE49-F238E27FC236}">
                  <a16:creationId xmlns:a16="http://schemas.microsoft.com/office/drawing/2014/main" id="{1261E27E-3B01-4653-B30A-3D9FB00C8C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46243" y="1715327"/>
              <a:ext cx="2087454" cy="3008669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EBA40BD-FA32-4650-981A-EB984FD46676}"/>
                </a:ext>
              </a:extLst>
            </p:cNvPr>
            <p:cNvSpPr txBox="1"/>
            <p:nvPr/>
          </p:nvSpPr>
          <p:spPr>
            <a:xfrm>
              <a:off x="1414408" y="2593496"/>
              <a:ext cx="5341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im</a:t>
              </a: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A9493C3D-DAD6-4229-AEAC-0186CB92B1DC}"/>
                </a:ext>
              </a:extLst>
            </p:cNvPr>
            <p:cNvCxnSpPr>
              <a:cxnSpLocks/>
            </p:cNvCxnSpPr>
            <p:nvPr/>
          </p:nvCxnSpPr>
          <p:spPr>
            <a:xfrm>
              <a:off x="1863199" y="2815852"/>
              <a:ext cx="331104" cy="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A28BC13-C472-4791-AC31-7E704097FD6A}"/>
                </a:ext>
              </a:extLst>
            </p:cNvPr>
            <p:cNvSpPr txBox="1"/>
            <p:nvPr/>
          </p:nvSpPr>
          <p:spPr>
            <a:xfrm rot="19809635">
              <a:off x="2205499" y="1216808"/>
              <a:ext cx="4443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75FCF23-EC19-4826-A27C-AA2D5B624C7E}"/>
                </a:ext>
              </a:extLst>
            </p:cNvPr>
            <p:cNvSpPr txBox="1"/>
            <p:nvPr/>
          </p:nvSpPr>
          <p:spPr>
            <a:xfrm rot="19809635">
              <a:off x="2644986" y="1271097"/>
              <a:ext cx="399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481107C-F7E8-4812-8513-93BA50D66ED7}"/>
                </a:ext>
              </a:extLst>
            </p:cNvPr>
            <p:cNvSpPr txBox="1"/>
            <p:nvPr/>
          </p:nvSpPr>
          <p:spPr>
            <a:xfrm rot="19809635">
              <a:off x="2887683" y="1235451"/>
              <a:ext cx="4443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2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7F55EC8-9D33-48A2-A293-9E3706CF8EBA}"/>
                </a:ext>
              </a:extLst>
            </p:cNvPr>
            <p:cNvSpPr txBox="1"/>
            <p:nvPr/>
          </p:nvSpPr>
          <p:spPr>
            <a:xfrm rot="19809635">
              <a:off x="3271336" y="1227974"/>
              <a:ext cx="399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BD96BC9-6D20-4A6B-855F-62EA34BAF23F}"/>
                </a:ext>
              </a:extLst>
            </p:cNvPr>
            <p:cNvSpPr txBox="1"/>
            <p:nvPr/>
          </p:nvSpPr>
          <p:spPr>
            <a:xfrm>
              <a:off x="1740732" y="588396"/>
              <a:ext cx="7637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ysate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CB08989-92CE-4B5C-9362-E91239FCF936}"/>
                </a:ext>
              </a:extLst>
            </p:cNvPr>
            <p:cNvSpPr txBox="1"/>
            <p:nvPr/>
          </p:nvSpPr>
          <p:spPr>
            <a:xfrm rot="19809635">
              <a:off x="3552966" y="1247690"/>
              <a:ext cx="4443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31A03E2-7559-41A4-8FD4-9B9025D767B0}"/>
                </a:ext>
              </a:extLst>
            </p:cNvPr>
            <p:cNvSpPr txBox="1"/>
            <p:nvPr/>
          </p:nvSpPr>
          <p:spPr>
            <a:xfrm rot="19809635">
              <a:off x="3956084" y="1216808"/>
              <a:ext cx="399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3</a:t>
              </a:r>
            </a:p>
          </p:txBody>
        </p: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E60190DB-ADFD-45B8-959B-EAB0B460FD6A}"/>
              </a:ext>
            </a:extLst>
          </p:cNvPr>
          <p:cNvGrpSpPr/>
          <p:nvPr/>
        </p:nvGrpSpPr>
        <p:grpSpPr>
          <a:xfrm>
            <a:off x="9707612" y="1025487"/>
            <a:ext cx="2221067" cy="4092260"/>
            <a:chOff x="4450464" y="588396"/>
            <a:chExt cx="2221067" cy="4092260"/>
          </a:xfrm>
        </p:grpSpPr>
        <p:pic>
          <p:nvPicPr>
            <p:cNvPr id="34" name="Picture 33" descr="A close up of a piece of paper&#10;&#10;Description automatically generated">
              <a:extLst>
                <a:ext uri="{FF2B5EF4-FFF2-40B4-BE49-F238E27FC236}">
                  <a16:creationId xmlns:a16="http://schemas.microsoft.com/office/drawing/2014/main" id="{03EC396C-8A42-413C-9988-5DF5A835E8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450464" y="1704713"/>
              <a:ext cx="1917980" cy="2975943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A5E8A2D-90C8-46A7-BBEB-65C949B4388E}"/>
                </a:ext>
              </a:extLst>
            </p:cNvPr>
            <p:cNvSpPr txBox="1"/>
            <p:nvPr/>
          </p:nvSpPr>
          <p:spPr>
            <a:xfrm>
              <a:off x="4879149" y="588396"/>
              <a:ext cx="10606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ulldown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A1E945B-AE98-48A8-8D3B-646790A6A41A}"/>
                </a:ext>
              </a:extLst>
            </p:cNvPr>
            <p:cNvSpPr txBox="1"/>
            <p:nvPr/>
          </p:nvSpPr>
          <p:spPr>
            <a:xfrm rot="19809635">
              <a:off x="4521478" y="1168196"/>
              <a:ext cx="4443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BA00CE0-61EA-4BE6-80EA-0C6429F5EECD}"/>
                </a:ext>
              </a:extLst>
            </p:cNvPr>
            <p:cNvSpPr txBox="1"/>
            <p:nvPr/>
          </p:nvSpPr>
          <p:spPr>
            <a:xfrm rot="19809635">
              <a:off x="4960965" y="1222485"/>
              <a:ext cx="399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56DDCD7-F14C-403A-A60E-3AA43C9FFD7A}"/>
                </a:ext>
              </a:extLst>
            </p:cNvPr>
            <p:cNvSpPr txBox="1"/>
            <p:nvPr/>
          </p:nvSpPr>
          <p:spPr>
            <a:xfrm rot="19809635">
              <a:off x="5203662" y="1186839"/>
              <a:ext cx="4443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2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F47527E-07DC-439B-84A6-C01FEB539CCB}"/>
                </a:ext>
              </a:extLst>
            </p:cNvPr>
            <p:cNvSpPr txBox="1"/>
            <p:nvPr/>
          </p:nvSpPr>
          <p:spPr>
            <a:xfrm rot="19809635">
              <a:off x="5587315" y="1179362"/>
              <a:ext cx="399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2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C4E470B-6509-4472-BEE1-F03138D1EDD0}"/>
                </a:ext>
              </a:extLst>
            </p:cNvPr>
            <p:cNvSpPr txBox="1"/>
            <p:nvPr/>
          </p:nvSpPr>
          <p:spPr>
            <a:xfrm rot="19809635">
              <a:off x="5868945" y="1199078"/>
              <a:ext cx="4443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3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FA660A3-921A-48C0-A671-E6B7C9227236}"/>
                </a:ext>
              </a:extLst>
            </p:cNvPr>
            <p:cNvSpPr txBox="1"/>
            <p:nvPr/>
          </p:nvSpPr>
          <p:spPr>
            <a:xfrm rot="19809635">
              <a:off x="6272063" y="1168196"/>
              <a:ext cx="399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124676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16FBA7C-1EB3-AD48-ADCF-3F3B5F789124}"/>
              </a:ext>
            </a:extLst>
          </p:cNvPr>
          <p:cNvSpPr txBox="1"/>
          <p:nvPr/>
        </p:nvSpPr>
        <p:spPr>
          <a:xfrm>
            <a:off x="0" y="132080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 4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2977622-7DC3-43A1-8960-452C42A99EF7}"/>
              </a:ext>
            </a:extLst>
          </p:cNvPr>
          <p:cNvGrpSpPr/>
          <p:nvPr/>
        </p:nvGrpSpPr>
        <p:grpSpPr>
          <a:xfrm>
            <a:off x="1316559" y="501455"/>
            <a:ext cx="4855049" cy="6711103"/>
            <a:chOff x="0" y="501455"/>
            <a:chExt cx="4855049" cy="6711103"/>
          </a:xfrm>
        </p:grpSpPr>
        <p:pic>
          <p:nvPicPr>
            <p:cNvPr id="5" name="Picture 4" descr="A close up of a guitar&#10;&#10;Description automatically generated">
              <a:extLst>
                <a:ext uri="{FF2B5EF4-FFF2-40B4-BE49-F238E27FC236}">
                  <a16:creationId xmlns:a16="http://schemas.microsoft.com/office/drawing/2014/main" id="{E3D073EA-62EF-4D3F-BCB4-A250ED3FA2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-12564"/>
            <a:stretch/>
          </p:blipFill>
          <p:spPr>
            <a:xfrm>
              <a:off x="677533" y="1452501"/>
              <a:ext cx="1212503" cy="5760057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85F47F6-B494-4474-8C50-DACF92B00668}"/>
                </a:ext>
              </a:extLst>
            </p:cNvPr>
            <p:cNvSpPr txBox="1"/>
            <p:nvPr/>
          </p:nvSpPr>
          <p:spPr>
            <a:xfrm rot="19809635">
              <a:off x="821255" y="612687"/>
              <a:ext cx="1989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lysate-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3D9E383-EF48-44F7-834F-675C1D802CC1}"/>
                </a:ext>
              </a:extLst>
            </p:cNvPr>
            <p:cNvSpPr txBox="1"/>
            <p:nvPr/>
          </p:nvSpPr>
          <p:spPr>
            <a:xfrm rot="19809635">
              <a:off x="1437767" y="534287"/>
              <a:ext cx="1944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lysate-L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58AA14C-B054-4BF2-9022-0691C72A8DBE}"/>
                </a:ext>
              </a:extLst>
            </p:cNvPr>
            <p:cNvSpPr txBox="1"/>
            <p:nvPr/>
          </p:nvSpPr>
          <p:spPr>
            <a:xfrm rot="19809635">
              <a:off x="2047364" y="529082"/>
              <a:ext cx="23255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D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78569A1-34E0-4693-A801-2611952AABA3}"/>
                </a:ext>
              </a:extLst>
            </p:cNvPr>
            <p:cNvSpPr txBox="1"/>
            <p:nvPr/>
          </p:nvSpPr>
          <p:spPr>
            <a:xfrm rot="19809635">
              <a:off x="2574360" y="501455"/>
              <a:ext cx="22806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L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712EA18-6ED1-40A0-B230-242A84B4B8CE}"/>
                </a:ext>
              </a:extLst>
            </p:cNvPr>
            <p:cNvSpPr txBox="1"/>
            <p:nvPr/>
          </p:nvSpPr>
          <p:spPr>
            <a:xfrm>
              <a:off x="0" y="2612357"/>
              <a:ext cx="541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</a:t>
              </a:r>
            </a:p>
          </p:txBody>
        </p:sp>
        <p:pic>
          <p:nvPicPr>
            <p:cNvPr id="11" name="Picture 10" descr="A picture containing building, sitting, covered, train&#10;&#10;Description automatically generated">
              <a:extLst>
                <a:ext uri="{FF2B5EF4-FFF2-40B4-BE49-F238E27FC236}">
                  <a16:creationId xmlns:a16="http://schemas.microsoft.com/office/drawing/2014/main" id="{02FCF69E-002D-4882-BDEA-85654CA622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6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93649" y="1581629"/>
              <a:ext cx="1212503" cy="5034698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ABAA5086-1EE8-4AFE-8F5F-F49BDDCF1D71}"/>
              </a:ext>
            </a:extLst>
          </p:cNvPr>
          <p:cNvGrpSpPr/>
          <p:nvPr/>
        </p:nvGrpSpPr>
        <p:grpSpPr>
          <a:xfrm>
            <a:off x="6437760" y="456210"/>
            <a:ext cx="5020461" cy="6062177"/>
            <a:chOff x="5121201" y="456210"/>
            <a:chExt cx="5020461" cy="6062177"/>
          </a:xfrm>
        </p:grpSpPr>
        <p:pic>
          <p:nvPicPr>
            <p:cNvPr id="13" name="Picture 12" descr="A close up of a building&#10;&#10;Description automatically generated">
              <a:extLst>
                <a:ext uri="{FF2B5EF4-FFF2-40B4-BE49-F238E27FC236}">
                  <a16:creationId xmlns:a16="http://schemas.microsoft.com/office/drawing/2014/main" id="{4AFF3F1B-5584-4F15-A056-D0E002A218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72955" y="1362934"/>
              <a:ext cx="1316846" cy="5138993"/>
            </a:xfrm>
            <a:prstGeom prst="rect">
              <a:avLst/>
            </a:prstGeom>
          </p:spPr>
        </p:pic>
        <p:pic>
          <p:nvPicPr>
            <p:cNvPr id="14" name="Picture 13" descr="A close up of a building&#10;&#10;Description automatically generated">
              <a:extLst>
                <a:ext uri="{FF2B5EF4-FFF2-40B4-BE49-F238E27FC236}">
                  <a16:creationId xmlns:a16="http://schemas.microsoft.com/office/drawing/2014/main" id="{8CFB44E5-5A4F-46F7-A155-07B2EC6E33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396250" y="1379394"/>
              <a:ext cx="1195988" cy="5138993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9226FB7-758C-4D53-8293-9F7E7EAAEE25}"/>
                </a:ext>
              </a:extLst>
            </p:cNvPr>
            <p:cNvSpPr txBox="1"/>
            <p:nvPr/>
          </p:nvSpPr>
          <p:spPr>
            <a:xfrm rot="19809635">
              <a:off x="5721571" y="560491"/>
              <a:ext cx="1989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lysate-D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397410F-7DF6-4435-A857-FAF66F481B07}"/>
                </a:ext>
              </a:extLst>
            </p:cNvPr>
            <p:cNvSpPr txBox="1"/>
            <p:nvPr/>
          </p:nvSpPr>
          <p:spPr>
            <a:xfrm rot="19809635">
              <a:off x="6338083" y="482091"/>
              <a:ext cx="1944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lysate-L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FCFD401-910E-469D-B12E-7F03EDE6ABD0}"/>
                </a:ext>
              </a:extLst>
            </p:cNvPr>
            <p:cNvSpPr txBox="1"/>
            <p:nvPr/>
          </p:nvSpPr>
          <p:spPr>
            <a:xfrm rot="19809635">
              <a:off x="7333977" y="483837"/>
              <a:ext cx="23255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D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4672AFD-9311-4A3F-9D6D-2FC0641A2557}"/>
                </a:ext>
              </a:extLst>
            </p:cNvPr>
            <p:cNvSpPr txBox="1"/>
            <p:nvPr/>
          </p:nvSpPr>
          <p:spPr>
            <a:xfrm rot="19809635">
              <a:off x="7860973" y="456210"/>
              <a:ext cx="22806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L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F65890B-E5D5-49A2-8F05-9D61C8D579BD}"/>
                </a:ext>
              </a:extLst>
            </p:cNvPr>
            <p:cNvSpPr txBox="1"/>
            <p:nvPr/>
          </p:nvSpPr>
          <p:spPr>
            <a:xfrm>
              <a:off x="5121201" y="2439860"/>
              <a:ext cx="5517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I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306172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0FAF75B-A3A3-E648-9058-4ACCACC36DA2}"/>
              </a:ext>
            </a:extLst>
          </p:cNvPr>
          <p:cNvSpPr txBox="1"/>
          <p:nvPr/>
        </p:nvSpPr>
        <p:spPr>
          <a:xfrm>
            <a:off x="0" y="95794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 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517B920-4E07-43B1-806F-2AA39CCA3E8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87037" y="1528762"/>
            <a:ext cx="2737631" cy="3943350"/>
          </a:xfrm>
          <a:prstGeom prst="rect">
            <a:avLst/>
          </a:prstGeom>
        </p:spPr>
      </p:pic>
      <p:pic>
        <p:nvPicPr>
          <p:cNvPr id="5" name="Picture 4" descr="A picture containing sitting, front, game, table&#10;&#10;Description automatically generated">
            <a:extLst>
              <a:ext uri="{FF2B5EF4-FFF2-40B4-BE49-F238E27FC236}">
                <a16:creationId xmlns:a16="http://schemas.microsoft.com/office/drawing/2014/main" id="{40D05C4F-E18D-4B9D-8733-7315EBEFD1F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431034" y="1528761"/>
            <a:ext cx="4804456" cy="39433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57A651C-13F3-4420-BA26-ADE305D1F252}"/>
              </a:ext>
            </a:extLst>
          </p:cNvPr>
          <p:cNvSpPr txBox="1"/>
          <p:nvPr/>
        </p:nvSpPr>
        <p:spPr>
          <a:xfrm>
            <a:off x="1598680" y="2475272"/>
            <a:ext cx="551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IM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63F8B46-855B-40AC-A29D-16409C533119}"/>
              </a:ext>
            </a:extLst>
          </p:cNvPr>
          <p:cNvSpPr txBox="1"/>
          <p:nvPr/>
        </p:nvSpPr>
        <p:spPr>
          <a:xfrm rot="19809635">
            <a:off x="3301202" y="632322"/>
            <a:ext cx="1351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68B45D9-73D5-44FC-80E1-22DE347B1D76}"/>
              </a:ext>
            </a:extLst>
          </p:cNvPr>
          <p:cNvSpPr txBox="1"/>
          <p:nvPr/>
        </p:nvSpPr>
        <p:spPr>
          <a:xfrm rot="19809635">
            <a:off x="3909066" y="632324"/>
            <a:ext cx="1306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lysate-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38ED8B-7EED-4CCF-8E33-3F1AE148BE1D}"/>
              </a:ext>
            </a:extLst>
          </p:cNvPr>
          <p:cNvSpPr txBox="1"/>
          <p:nvPr/>
        </p:nvSpPr>
        <p:spPr>
          <a:xfrm rot="19809635">
            <a:off x="4152856" y="595903"/>
            <a:ext cx="19895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A314E4C-A17C-46A5-950B-E294916FA4AA}"/>
              </a:ext>
            </a:extLst>
          </p:cNvPr>
          <p:cNvSpPr txBox="1"/>
          <p:nvPr/>
        </p:nvSpPr>
        <p:spPr>
          <a:xfrm rot="19809635">
            <a:off x="4769368" y="517503"/>
            <a:ext cx="1944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lysate-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468920-D065-41CD-BD7C-24C0495B23D3}"/>
              </a:ext>
            </a:extLst>
          </p:cNvPr>
          <p:cNvSpPr txBox="1"/>
          <p:nvPr/>
        </p:nvSpPr>
        <p:spPr>
          <a:xfrm rot="19809635">
            <a:off x="6082421" y="669874"/>
            <a:ext cx="1687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pulldown-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F174BA1-4780-4E86-AD42-04C6701FD776}"/>
              </a:ext>
            </a:extLst>
          </p:cNvPr>
          <p:cNvSpPr txBox="1"/>
          <p:nvPr/>
        </p:nvSpPr>
        <p:spPr>
          <a:xfrm rot="19809635">
            <a:off x="6566670" y="652718"/>
            <a:ext cx="1642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pulldown-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8B845E8-4E4C-4B30-B316-A76F5D6E6A02}"/>
              </a:ext>
            </a:extLst>
          </p:cNvPr>
          <p:cNvSpPr txBox="1"/>
          <p:nvPr/>
        </p:nvSpPr>
        <p:spPr>
          <a:xfrm rot="19809635">
            <a:off x="6891329" y="502789"/>
            <a:ext cx="2325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pulldown-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6D7232F-FB81-4879-978A-2F20075593EE}"/>
              </a:ext>
            </a:extLst>
          </p:cNvPr>
          <p:cNvSpPr txBox="1"/>
          <p:nvPr/>
        </p:nvSpPr>
        <p:spPr>
          <a:xfrm rot="19809635">
            <a:off x="7418325" y="475162"/>
            <a:ext cx="2280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Y </a:t>
            </a:r>
            <a:r>
              <a:rPr lang="en-US" dirty="0" err="1"/>
              <a:t>sortag</a:t>
            </a:r>
            <a:r>
              <a:rPr lang="en-US" dirty="0"/>
              <a:t> pulldown-L</a:t>
            </a:r>
          </a:p>
        </p:txBody>
      </p:sp>
    </p:spTree>
    <p:extLst>
      <p:ext uri="{BB962C8B-B14F-4D97-AF65-F5344CB8AC3E}">
        <p14:creationId xmlns:p14="http://schemas.microsoft.com/office/powerpoint/2010/main" val="42169206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141F7E4-F3CB-4AED-9622-66EF23C0C1A5}"/>
              </a:ext>
            </a:extLst>
          </p:cNvPr>
          <p:cNvGrpSpPr/>
          <p:nvPr/>
        </p:nvGrpSpPr>
        <p:grpSpPr>
          <a:xfrm>
            <a:off x="1775978" y="469836"/>
            <a:ext cx="8039378" cy="5908567"/>
            <a:chOff x="1759649" y="774637"/>
            <a:chExt cx="8039378" cy="5908567"/>
          </a:xfrm>
        </p:grpSpPr>
        <p:pic>
          <p:nvPicPr>
            <p:cNvPr id="5" name="Picture 4" descr="A close up of a building&#10;&#10;Description automatically generated">
              <a:extLst>
                <a:ext uri="{FF2B5EF4-FFF2-40B4-BE49-F238E27FC236}">
                  <a16:creationId xmlns:a16="http://schemas.microsoft.com/office/drawing/2014/main" id="{9918DC77-E1F1-1B4C-99BF-AB5609A6D2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33675" y="1738311"/>
              <a:ext cx="2543177" cy="4944893"/>
            </a:xfrm>
            <a:prstGeom prst="rect">
              <a:avLst/>
            </a:prstGeom>
          </p:spPr>
        </p:pic>
        <p:pic>
          <p:nvPicPr>
            <p:cNvPr id="9" name="Picture 8" descr="A close up of a train&#10;&#10;Description automatically generated">
              <a:extLst>
                <a:ext uri="{FF2B5EF4-FFF2-40B4-BE49-F238E27FC236}">
                  <a16:creationId xmlns:a16="http://schemas.microsoft.com/office/drawing/2014/main" id="{E32D2D05-4551-6F4C-8ABE-8A782BF5FC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99124" y="1735192"/>
              <a:ext cx="3759201" cy="4930502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8F890F0-2D74-8949-A352-3961DD8F2188}"/>
                </a:ext>
              </a:extLst>
            </p:cNvPr>
            <p:cNvSpPr txBox="1"/>
            <p:nvPr/>
          </p:nvSpPr>
          <p:spPr>
            <a:xfrm rot="19809635">
              <a:off x="3401215" y="931797"/>
              <a:ext cx="13511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lysate-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3084EF8-619F-354D-B60A-0CE69BAC0CE7}"/>
                </a:ext>
              </a:extLst>
            </p:cNvPr>
            <p:cNvSpPr txBox="1"/>
            <p:nvPr/>
          </p:nvSpPr>
          <p:spPr>
            <a:xfrm rot="19809635">
              <a:off x="4009079" y="931799"/>
              <a:ext cx="13062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lysate-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5093F50-8020-BE4B-A73D-F92F0DE9B9E6}"/>
                </a:ext>
              </a:extLst>
            </p:cNvPr>
            <p:cNvSpPr txBox="1"/>
            <p:nvPr/>
          </p:nvSpPr>
          <p:spPr>
            <a:xfrm rot="19809635">
              <a:off x="4252869" y="895378"/>
              <a:ext cx="19895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lysate-D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1DEE265-CD92-D342-B85B-EE2F9F4B4F93}"/>
                </a:ext>
              </a:extLst>
            </p:cNvPr>
            <p:cNvSpPr txBox="1"/>
            <p:nvPr/>
          </p:nvSpPr>
          <p:spPr>
            <a:xfrm rot="19809635">
              <a:off x="4869381" y="816978"/>
              <a:ext cx="1944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lysate-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08403A3-0567-4E44-A308-68B41FC0A4F4}"/>
                </a:ext>
              </a:extLst>
            </p:cNvPr>
            <p:cNvSpPr txBox="1"/>
            <p:nvPr/>
          </p:nvSpPr>
          <p:spPr>
            <a:xfrm rot="19809635">
              <a:off x="6182434" y="969349"/>
              <a:ext cx="16871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pulldown-D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F15C127-8EA6-8540-9B63-4B8B0D161B2B}"/>
                </a:ext>
              </a:extLst>
            </p:cNvPr>
            <p:cNvSpPr txBox="1"/>
            <p:nvPr/>
          </p:nvSpPr>
          <p:spPr>
            <a:xfrm rot="19809635">
              <a:off x="6666683" y="952193"/>
              <a:ext cx="16423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pulldown-L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F23D009-8B5E-EA42-921E-66FE44A2308B}"/>
                </a:ext>
              </a:extLst>
            </p:cNvPr>
            <p:cNvSpPr txBox="1"/>
            <p:nvPr/>
          </p:nvSpPr>
          <p:spPr>
            <a:xfrm rot="19809635">
              <a:off x="6991342" y="802264"/>
              <a:ext cx="23255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D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A9F54CF-C85A-1D49-8F3C-07842A545801}"/>
                </a:ext>
              </a:extLst>
            </p:cNvPr>
            <p:cNvSpPr txBox="1"/>
            <p:nvPr/>
          </p:nvSpPr>
          <p:spPr>
            <a:xfrm rot="19809635">
              <a:off x="7518338" y="774637"/>
              <a:ext cx="22806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 </a:t>
              </a:r>
              <a:r>
                <a:rPr lang="en-US" dirty="0" err="1"/>
                <a:t>sortag</a:t>
              </a:r>
              <a:r>
                <a:rPr lang="en-US" dirty="0"/>
                <a:t> pulldown-L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F66EBD7-81FB-EB47-92A8-12363C3E129E}"/>
                </a:ext>
              </a:extLst>
            </p:cNvPr>
            <p:cNvSpPr txBox="1"/>
            <p:nvPr/>
          </p:nvSpPr>
          <p:spPr>
            <a:xfrm>
              <a:off x="1759649" y="3429000"/>
              <a:ext cx="541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R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187595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69B2AC3-9E05-EA44-AF4A-B7C0F214102B}"/>
              </a:ext>
            </a:extLst>
          </p:cNvPr>
          <p:cNvSpPr txBox="1"/>
          <p:nvPr/>
        </p:nvSpPr>
        <p:spPr>
          <a:xfrm>
            <a:off x="853864" y="366123"/>
            <a:ext cx="2480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data for figure S7, b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EC96B2B-1A27-4FC8-9C34-43B080DD01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81394"/>
              </p:ext>
            </p:extLst>
          </p:nvPr>
        </p:nvGraphicFramePr>
        <p:xfrm>
          <a:off x="7796653" y="1389591"/>
          <a:ext cx="2146300" cy="2438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44693">
                  <a:extLst>
                    <a:ext uri="{9D8B030D-6E8A-4147-A177-3AD203B41FA5}">
                      <a16:colId xmlns:a16="http://schemas.microsoft.com/office/drawing/2014/main" val="1428549911"/>
                    </a:ext>
                  </a:extLst>
                </a:gridCol>
                <a:gridCol w="1001607">
                  <a:extLst>
                    <a:ext uri="{9D8B030D-6E8A-4147-A177-3AD203B41FA5}">
                      <a16:colId xmlns:a16="http://schemas.microsoft.com/office/drawing/2014/main" val="4242311955"/>
                    </a:ext>
                  </a:extLst>
                </a:gridCol>
              </a:tblGrid>
              <a:tr h="2032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Dark light differenc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245338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1033233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8318751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3.2500939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4301891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.00582795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8736142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9421997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RY-sortag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4634270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981610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RY-sortag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8404781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965703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RY-sortag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4715232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7082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564431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RY-delta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06541283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2680681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RY-delta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01126848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5700004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RY-delta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0795493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6110834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2A1CC78-C137-4F84-85A9-11968F6DB44C}"/>
              </a:ext>
            </a:extLst>
          </p:cNvPr>
          <p:cNvSpPr txBox="1"/>
          <p:nvPr/>
        </p:nvSpPr>
        <p:spPr>
          <a:xfrm>
            <a:off x="6447082" y="835593"/>
            <a:ext cx="2114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Individual datapoint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E29EAF3-3BF3-4E8D-95CA-8BA872B22F78}"/>
                  </a:ext>
                </a:extLst>
              </p:cNvPr>
              <p:cNvSpPr txBox="1"/>
              <p:nvPr/>
            </p:nvSpPr>
            <p:spPr>
              <a:xfrm>
                <a:off x="1165860" y="5380383"/>
                <a:ext cx="4656275" cy="4412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b="0" dirty="0"/>
                  <a:t>Dark-light difference</a:t>
                </a:r>
                <a14:m>
                  <m:oMath xmlns:m="http://schemas.openxmlformats.org/officeDocument/2006/math">
                    <m:r>
                      <a:rPr lang="en-US" b="0" i="1" smtClean="0">
                        <a:latin typeface="Cambria Math" panose="02040503050406030204" pitchFamily="18" charset="0"/>
                      </a:rPr>
                      <m:t>=</m:t>
                    </m:r>
                    <m:f>
                      <m:fPr>
                        <m:ctrlPr>
                          <a:rPr lang="en-US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𝐴𝑓𝑓𝑖𝑛𝑖𝑡𝑦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𝑖𝑛𝑑𝑒𝑥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(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𝑙𝑖𝑔h𝑡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𝑠𝑎𝑚𝑝𝑙𝑒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)</m:t>
                        </m:r>
                      </m:num>
                      <m:den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𝐴𝑓𝑓𝑖𝑛𝑖𝑡𝑦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𝑖𝑛𝑑𝑒𝑥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(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𝑑𝑎𝑟𝑘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𝑠𝑎𝑚𝑝𝑙𝑒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)</m:t>
                        </m:r>
                      </m:den>
                    </m:f>
                  </m:oMath>
                </a14:m>
                <a:endParaRPr lang="en-US" dirty="0"/>
              </a:p>
            </p:txBody>
          </p:sp>
        </mc:Choice>
        <mc:Fallback xmlns=""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E29EAF3-3BF3-4E8D-95CA-8BA872B22F7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165860" y="5380383"/>
                <a:ext cx="4656275" cy="441211"/>
              </a:xfrm>
              <a:prstGeom prst="rect">
                <a:avLst/>
              </a:prstGeom>
              <a:blipFill>
                <a:blip r:embed="rId2"/>
                <a:stretch>
                  <a:fillRect l="-3010" t="-2778" r="-1571" b="-18056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7" name="Rectangle 6">
            <a:extLst>
              <a:ext uri="{FF2B5EF4-FFF2-40B4-BE49-F238E27FC236}">
                <a16:creationId xmlns:a16="http://schemas.microsoft.com/office/drawing/2014/main" id="{608A33DA-48A8-45E8-A63E-A56DD970EF4F}"/>
              </a:ext>
            </a:extLst>
          </p:cNvPr>
          <p:cNvSpPr/>
          <p:nvPr/>
        </p:nvSpPr>
        <p:spPr>
          <a:xfrm>
            <a:off x="7255317" y="4370971"/>
            <a:ext cx="30657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Single sample t test- two tailed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FEACC9D1-6090-43D2-88C6-065572F2F6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2669980"/>
              </p:ext>
            </p:extLst>
          </p:nvPr>
        </p:nvGraphicFramePr>
        <p:xfrm>
          <a:off x="7796653" y="4876883"/>
          <a:ext cx="2476500" cy="406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5500">
                  <a:extLst>
                    <a:ext uri="{9D8B030D-6E8A-4147-A177-3AD203B41FA5}">
                      <a16:colId xmlns:a16="http://schemas.microsoft.com/office/drawing/2014/main" val="343588123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721021873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703991811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W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RY-sort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ry-del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0270423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45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414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2920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5766497"/>
                  </a:ext>
                </a:extLst>
              </a:tr>
            </a:tbl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0B8D79AA-9DFC-4F53-8DEE-690F20B7D8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2254300"/>
              </p:ext>
            </p:extLst>
          </p:nvPr>
        </p:nvGraphicFramePr>
        <p:xfrm>
          <a:off x="1437445" y="1238128"/>
          <a:ext cx="4572000" cy="3270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30556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564</Words>
  <Application>Microsoft Office PowerPoint</Application>
  <PresentationFormat>Widescreen</PresentationFormat>
  <Paragraphs>259</Paragraphs>
  <Slides>2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8" baseType="lpstr">
      <vt:lpstr>Arial</vt:lpstr>
      <vt:lpstr>Calibri</vt:lpstr>
      <vt:lpstr>Calibri Light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fan Lin</dc:creator>
  <cp:lastModifiedBy>Siddarth Chandrasekaran</cp:lastModifiedBy>
  <cp:revision>27</cp:revision>
  <dcterms:created xsi:type="dcterms:W3CDTF">2020-11-24T20:55:14Z</dcterms:created>
  <dcterms:modified xsi:type="dcterms:W3CDTF">2020-11-27T18:38:40Z</dcterms:modified>
</cp:coreProperties>
</file>